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14" y="11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221004_Yoshida\20220806_Yoshida\Excel_Data\2022.3.6Tabe3&#12487;&#12540;&#12479;&amp;Fig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221004_Yoshida\20220806_Yoshida\Excel_Data\2022.3.6Tabe3&#12487;&#12540;&#12479;&amp;Fig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221004_Yoshida\20220806_Yoshida\Excel_Data\2022.3.6Tabe3&#12487;&#12540;&#12479;&amp;Fig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20221004_Yoshida\20220806_Yoshida\Excel_Data\2022.3.6Tabe3&#12487;&#12540;&#12479;&amp;Fig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34283815361633"/>
          <c:y val="5.091761042232823E-2"/>
          <c:w val="0.72171129355363817"/>
          <c:h val="0.68793035897603905"/>
        </c:manualLayout>
      </c:layout>
      <c:scatterChart>
        <c:scatterStyle val="lineMarker"/>
        <c:varyColors val="0"/>
        <c:ser>
          <c:idx val="0"/>
          <c:order val="0"/>
          <c:tx>
            <c:strRef>
              <c:f>文字数と視力!$B$1</c:f>
              <c:strCache>
                <c:ptCount val="1"/>
                <c:pt idx="0">
                  <c:v>Number of letter correctly rea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-0.1652147276299743"/>
                  <c:y val="0.1436098688377782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dirty="0"/>
                      <a:t>y = -1852x + 1861</a:t>
                    </a:r>
                  </a:p>
                  <a:p>
                    <a:pPr>
                      <a:defRPr lang="ja-JP"/>
                    </a:pPr>
                    <a:r>
                      <a:rPr lang="en-US" dirty="0"/>
                      <a:t>   r = 0.542 ( p &lt; 0.01)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文字数と視力!$A$2:$A$59</c:f>
              <c:numCache>
                <c:formatCode>General</c:formatCode>
                <c:ptCount val="58"/>
                <c:pt idx="0">
                  <c:v>0.3</c:v>
                </c:pt>
                <c:pt idx="1">
                  <c:v>0.4</c:v>
                </c:pt>
                <c:pt idx="2">
                  <c:v>0.4</c:v>
                </c:pt>
                <c:pt idx="3">
                  <c:v>0.1</c:v>
                </c:pt>
                <c:pt idx="4">
                  <c:v>0.4</c:v>
                </c:pt>
                <c:pt idx="5">
                  <c:v>0.15</c:v>
                </c:pt>
                <c:pt idx="6">
                  <c:v>0.3</c:v>
                </c:pt>
                <c:pt idx="7">
                  <c:v>0.3</c:v>
                </c:pt>
                <c:pt idx="8">
                  <c:v>0.4</c:v>
                </c:pt>
                <c:pt idx="9">
                  <c:v>0.3</c:v>
                </c:pt>
                <c:pt idx="10">
                  <c:v>0.4</c:v>
                </c:pt>
                <c:pt idx="11">
                  <c:v>0.4</c:v>
                </c:pt>
                <c:pt idx="12">
                  <c:v>0.2</c:v>
                </c:pt>
                <c:pt idx="13">
                  <c:v>0.15</c:v>
                </c:pt>
                <c:pt idx="14">
                  <c:v>0.2</c:v>
                </c:pt>
                <c:pt idx="15">
                  <c:v>0.2</c:v>
                </c:pt>
                <c:pt idx="16">
                  <c:v>0.1</c:v>
                </c:pt>
                <c:pt idx="17">
                  <c:v>-0.2</c:v>
                </c:pt>
                <c:pt idx="18">
                  <c:v>0.3</c:v>
                </c:pt>
                <c:pt idx="19">
                  <c:v>0.1</c:v>
                </c:pt>
                <c:pt idx="20">
                  <c:v>0.1</c:v>
                </c:pt>
                <c:pt idx="21">
                  <c:v>0.15</c:v>
                </c:pt>
                <c:pt idx="22">
                  <c:v>0.2</c:v>
                </c:pt>
                <c:pt idx="23">
                  <c:v>0</c:v>
                </c:pt>
                <c:pt idx="24">
                  <c:v>0.3</c:v>
                </c:pt>
                <c:pt idx="25">
                  <c:v>0.05</c:v>
                </c:pt>
                <c:pt idx="26">
                  <c:v>-0.1</c:v>
                </c:pt>
              </c:numCache>
            </c:numRef>
          </c:xVal>
          <c:yVal>
            <c:numRef>
              <c:f>文字数と視力!$B$2:$B$59</c:f>
              <c:numCache>
                <c:formatCode>General</c:formatCode>
                <c:ptCount val="58"/>
                <c:pt idx="0">
                  <c:v>537</c:v>
                </c:pt>
                <c:pt idx="1">
                  <c:v>484</c:v>
                </c:pt>
                <c:pt idx="2">
                  <c:v>1155</c:v>
                </c:pt>
                <c:pt idx="3">
                  <c:v>1509</c:v>
                </c:pt>
                <c:pt idx="4">
                  <c:v>1154</c:v>
                </c:pt>
                <c:pt idx="5">
                  <c:v>1160</c:v>
                </c:pt>
                <c:pt idx="6">
                  <c:v>808</c:v>
                </c:pt>
                <c:pt idx="7">
                  <c:v>1246</c:v>
                </c:pt>
                <c:pt idx="8">
                  <c:v>1185</c:v>
                </c:pt>
                <c:pt idx="9">
                  <c:v>1531</c:v>
                </c:pt>
                <c:pt idx="10">
                  <c:v>766</c:v>
                </c:pt>
                <c:pt idx="11">
                  <c:v>882</c:v>
                </c:pt>
                <c:pt idx="12">
                  <c:v>2841</c:v>
                </c:pt>
                <c:pt idx="13">
                  <c:v>2277</c:v>
                </c:pt>
                <c:pt idx="14">
                  <c:v>1875</c:v>
                </c:pt>
                <c:pt idx="15">
                  <c:v>1483</c:v>
                </c:pt>
                <c:pt idx="16">
                  <c:v>1264</c:v>
                </c:pt>
                <c:pt idx="17">
                  <c:v>1688</c:v>
                </c:pt>
                <c:pt idx="18">
                  <c:v>1350</c:v>
                </c:pt>
                <c:pt idx="19">
                  <c:v>1723</c:v>
                </c:pt>
                <c:pt idx="20">
                  <c:v>2199</c:v>
                </c:pt>
                <c:pt idx="21">
                  <c:v>1803</c:v>
                </c:pt>
                <c:pt idx="22">
                  <c:v>1811</c:v>
                </c:pt>
                <c:pt idx="23">
                  <c:v>1826</c:v>
                </c:pt>
                <c:pt idx="24">
                  <c:v>1866</c:v>
                </c:pt>
                <c:pt idx="25">
                  <c:v>1481</c:v>
                </c:pt>
                <c:pt idx="26">
                  <c:v>19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2F8-4464-9A15-F5235C605C9F}"/>
            </c:ext>
          </c:extLst>
        </c:ser>
        <c:ser>
          <c:idx val="1"/>
          <c:order val="1"/>
          <c:tx>
            <c:v>P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力!$A$2:$A$59</c:f>
              <c:numCache>
                <c:formatCode>General</c:formatCode>
                <c:ptCount val="58"/>
                <c:pt idx="0">
                  <c:v>0.3</c:v>
                </c:pt>
                <c:pt idx="1">
                  <c:v>0.4</c:v>
                </c:pt>
                <c:pt idx="2">
                  <c:v>0.4</c:v>
                </c:pt>
                <c:pt idx="3">
                  <c:v>0.1</c:v>
                </c:pt>
                <c:pt idx="4">
                  <c:v>0.4</c:v>
                </c:pt>
                <c:pt idx="5">
                  <c:v>0.15</c:v>
                </c:pt>
                <c:pt idx="6">
                  <c:v>0.3</c:v>
                </c:pt>
                <c:pt idx="7">
                  <c:v>0.3</c:v>
                </c:pt>
                <c:pt idx="8">
                  <c:v>0.4</c:v>
                </c:pt>
                <c:pt idx="9">
                  <c:v>0.3</c:v>
                </c:pt>
                <c:pt idx="10">
                  <c:v>0.4</c:v>
                </c:pt>
                <c:pt idx="11">
                  <c:v>0.4</c:v>
                </c:pt>
                <c:pt idx="12">
                  <c:v>0.2</c:v>
                </c:pt>
                <c:pt idx="13">
                  <c:v>0.15</c:v>
                </c:pt>
                <c:pt idx="14">
                  <c:v>0.2</c:v>
                </c:pt>
                <c:pt idx="15">
                  <c:v>0.2</c:v>
                </c:pt>
                <c:pt idx="16">
                  <c:v>0.1</c:v>
                </c:pt>
                <c:pt idx="17">
                  <c:v>-0.2</c:v>
                </c:pt>
                <c:pt idx="18">
                  <c:v>0.3</c:v>
                </c:pt>
                <c:pt idx="19">
                  <c:v>0.1</c:v>
                </c:pt>
                <c:pt idx="20">
                  <c:v>0.1</c:v>
                </c:pt>
                <c:pt idx="21">
                  <c:v>0.15</c:v>
                </c:pt>
                <c:pt idx="22">
                  <c:v>0.2</c:v>
                </c:pt>
                <c:pt idx="23">
                  <c:v>0</c:v>
                </c:pt>
                <c:pt idx="24">
                  <c:v>0.3</c:v>
                </c:pt>
                <c:pt idx="25">
                  <c:v>0.05</c:v>
                </c:pt>
                <c:pt idx="26">
                  <c:v>-0.1</c:v>
                </c:pt>
              </c:numCache>
            </c:numRef>
          </c:xVal>
          <c:yVal>
            <c:numRef>
              <c:f>文字数と視力!$F$2:$F$59</c:f>
              <c:numCache>
                <c:formatCode>0.0_);[Red]\(0.0\)</c:formatCode>
                <c:ptCount val="58"/>
                <c:pt idx="0">
                  <c:v>2289.959036012353</c:v>
                </c:pt>
                <c:pt idx="1">
                  <c:v>2124.8638687833218</c:v>
                </c:pt>
                <c:pt idx="2">
                  <c:v>2124.8638687833218</c:v>
                </c:pt>
                <c:pt idx="3">
                  <c:v>2662.4644275964524</c:v>
                </c:pt>
                <c:pt idx="4">
                  <c:v>2124.8638687833218</c:v>
                </c:pt>
                <c:pt idx="5">
                  <c:v>2563.9916111672928</c:v>
                </c:pt>
                <c:pt idx="6">
                  <c:v>2289.959036012353</c:v>
                </c:pt>
                <c:pt idx="7">
                  <c:v>2289.959036012353</c:v>
                </c:pt>
                <c:pt idx="8">
                  <c:v>2124.8638687833218</c:v>
                </c:pt>
                <c:pt idx="9">
                  <c:v>2289.959036012353</c:v>
                </c:pt>
                <c:pt idx="10">
                  <c:v>2124.8638687833218</c:v>
                </c:pt>
                <c:pt idx="11">
                  <c:v>2124.8638687833218</c:v>
                </c:pt>
                <c:pt idx="12">
                  <c:v>2469.0727792948564</c:v>
                </c:pt>
                <c:pt idx="13">
                  <c:v>2563.9916111672928</c:v>
                </c:pt>
                <c:pt idx="14">
                  <c:v>2469.0727792948564</c:v>
                </c:pt>
                <c:pt idx="15">
                  <c:v>2469.0727792948564</c:v>
                </c:pt>
                <c:pt idx="16">
                  <c:v>2662.4644275964524</c:v>
                </c:pt>
                <c:pt idx="17">
                  <c:v>3322.3049984017766</c:v>
                </c:pt>
                <c:pt idx="18">
                  <c:v>2289.959036012353</c:v>
                </c:pt>
                <c:pt idx="19">
                  <c:v>2662.4644275964524</c:v>
                </c:pt>
                <c:pt idx="20">
                  <c:v>2662.4644275964524</c:v>
                </c:pt>
                <c:pt idx="21">
                  <c:v>2563.9916111672928</c:v>
                </c:pt>
                <c:pt idx="22">
                  <c:v>2469.0727792948564</c:v>
                </c:pt>
                <c:pt idx="23">
                  <c:v>2869.7862684460906</c:v>
                </c:pt>
                <c:pt idx="24">
                  <c:v>2289.959036012353</c:v>
                </c:pt>
                <c:pt idx="25">
                  <c:v>2764.4283772163653</c:v>
                </c:pt>
                <c:pt idx="26">
                  <c:v>3090.153316493525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2F8-4464-9A15-F5235C605C9F}"/>
            </c:ext>
          </c:extLst>
        </c:ser>
        <c:ser>
          <c:idx val="2"/>
          <c:order val="2"/>
          <c:tx>
            <c:v>P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力!$A$2:$A$59</c:f>
              <c:numCache>
                <c:formatCode>General</c:formatCode>
                <c:ptCount val="58"/>
                <c:pt idx="0">
                  <c:v>0.3</c:v>
                </c:pt>
                <c:pt idx="1">
                  <c:v>0.4</c:v>
                </c:pt>
                <c:pt idx="2">
                  <c:v>0.4</c:v>
                </c:pt>
                <c:pt idx="3">
                  <c:v>0.1</c:v>
                </c:pt>
                <c:pt idx="4">
                  <c:v>0.4</c:v>
                </c:pt>
                <c:pt idx="5">
                  <c:v>0.15</c:v>
                </c:pt>
                <c:pt idx="6">
                  <c:v>0.3</c:v>
                </c:pt>
                <c:pt idx="7">
                  <c:v>0.3</c:v>
                </c:pt>
                <c:pt idx="8">
                  <c:v>0.4</c:v>
                </c:pt>
                <c:pt idx="9">
                  <c:v>0.3</c:v>
                </c:pt>
                <c:pt idx="10">
                  <c:v>0.4</c:v>
                </c:pt>
                <c:pt idx="11">
                  <c:v>0.4</c:v>
                </c:pt>
                <c:pt idx="12">
                  <c:v>0.2</c:v>
                </c:pt>
                <c:pt idx="13">
                  <c:v>0.15</c:v>
                </c:pt>
                <c:pt idx="14">
                  <c:v>0.2</c:v>
                </c:pt>
                <c:pt idx="15">
                  <c:v>0.2</c:v>
                </c:pt>
                <c:pt idx="16">
                  <c:v>0.1</c:v>
                </c:pt>
                <c:pt idx="17">
                  <c:v>-0.2</c:v>
                </c:pt>
                <c:pt idx="18">
                  <c:v>0.3</c:v>
                </c:pt>
                <c:pt idx="19">
                  <c:v>0.1</c:v>
                </c:pt>
                <c:pt idx="20">
                  <c:v>0.1</c:v>
                </c:pt>
                <c:pt idx="21">
                  <c:v>0.15</c:v>
                </c:pt>
                <c:pt idx="22">
                  <c:v>0.2</c:v>
                </c:pt>
                <c:pt idx="23">
                  <c:v>0</c:v>
                </c:pt>
                <c:pt idx="24">
                  <c:v>0.3</c:v>
                </c:pt>
                <c:pt idx="25">
                  <c:v>0.05</c:v>
                </c:pt>
                <c:pt idx="26">
                  <c:v>-0.1</c:v>
                </c:pt>
              </c:numCache>
            </c:numRef>
          </c:xVal>
          <c:yVal>
            <c:numRef>
              <c:f>文字数と視力!$G$2:$G$59</c:f>
              <c:numCache>
                <c:formatCode>0.0_);[Red]\(0.0\)</c:formatCode>
                <c:ptCount val="58"/>
                <c:pt idx="0">
                  <c:v>320.26537343646578</c:v>
                </c:pt>
                <c:pt idx="1">
                  <c:v>114.96290287022134</c:v>
                </c:pt>
                <c:pt idx="2">
                  <c:v>114.96290287022134</c:v>
                </c:pt>
                <c:pt idx="3">
                  <c:v>688.55525744291765</c:v>
                </c:pt>
                <c:pt idx="4">
                  <c:v>114.96290287022134</c:v>
                </c:pt>
                <c:pt idx="5">
                  <c:v>601.82925497443921</c:v>
                </c:pt>
                <c:pt idx="6">
                  <c:v>320.26537343646578</c:v>
                </c:pt>
                <c:pt idx="7">
                  <c:v>320.26537343646578</c:v>
                </c:pt>
                <c:pt idx="8">
                  <c:v>114.96290287022134</c:v>
                </c:pt>
                <c:pt idx="9">
                  <c:v>320.26537343646578</c:v>
                </c:pt>
                <c:pt idx="10">
                  <c:v>114.96290287022134</c:v>
                </c:pt>
                <c:pt idx="11">
                  <c:v>114.96290287022134</c:v>
                </c:pt>
                <c:pt idx="12">
                  <c:v>511.54926794923756</c:v>
                </c:pt>
                <c:pt idx="13">
                  <c:v>601.82925497443921</c:v>
                </c:pt>
                <c:pt idx="14">
                  <c:v>511.54926794923756</c:v>
                </c:pt>
                <c:pt idx="15">
                  <c:v>511.54926794923756</c:v>
                </c:pt>
                <c:pt idx="16">
                  <c:v>688.55525744291765</c:v>
                </c:pt>
                <c:pt idx="17">
                  <c:v>1139.9076000234195</c:v>
                </c:pt>
                <c:pt idx="18">
                  <c:v>320.26537343646578</c:v>
                </c:pt>
                <c:pt idx="19">
                  <c:v>688.55525744291765</c:v>
                </c:pt>
                <c:pt idx="20">
                  <c:v>688.55525744291765</c:v>
                </c:pt>
                <c:pt idx="21">
                  <c:v>601.82925497443921</c:v>
                </c:pt>
                <c:pt idx="22">
                  <c:v>511.54926794923756</c:v>
                </c:pt>
                <c:pt idx="23">
                  <c:v>851.63105438855496</c:v>
                </c:pt>
                <c:pt idx="24">
                  <c:v>320.26537343646578</c:v>
                </c:pt>
                <c:pt idx="25">
                  <c:v>771.79012672064198</c:v>
                </c:pt>
                <c:pt idx="26">
                  <c:v>1001.66164413639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2F8-4464-9A15-F5235C605C9F}"/>
            </c:ext>
          </c:extLst>
        </c:ser>
        <c:ser>
          <c:idx val="3"/>
          <c:order val="3"/>
          <c:tx>
            <c:v>C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力!$A$2:$A$59</c:f>
              <c:numCache>
                <c:formatCode>General</c:formatCode>
                <c:ptCount val="58"/>
                <c:pt idx="0">
                  <c:v>0.3</c:v>
                </c:pt>
                <c:pt idx="1">
                  <c:v>0.4</c:v>
                </c:pt>
                <c:pt idx="2">
                  <c:v>0.4</c:v>
                </c:pt>
                <c:pt idx="3">
                  <c:v>0.1</c:v>
                </c:pt>
                <c:pt idx="4">
                  <c:v>0.4</c:v>
                </c:pt>
                <c:pt idx="5">
                  <c:v>0.15</c:v>
                </c:pt>
                <c:pt idx="6">
                  <c:v>0.3</c:v>
                </c:pt>
                <c:pt idx="7">
                  <c:v>0.3</c:v>
                </c:pt>
                <c:pt idx="8">
                  <c:v>0.4</c:v>
                </c:pt>
                <c:pt idx="9">
                  <c:v>0.3</c:v>
                </c:pt>
                <c:pt idx="10">
                  <c:v>0.4</c:v>
                </c:pt>
                <c:pt idx="11">
                  <c:v>0.4</c:v>
                </c:pt>
                <c:pt idx="12">
                  <c:v>0.2</c:v>
                </c:pt>
                <c:pt idx="13">
                  <c:v>0.15</c:v>
                </c:pt>
                <c:pt idx="14">
                  <c:v>0.2</c:v>
                </c:pt>
                <c:pt idx="15">
                  <c:v>0.2</c:v>
                </c:pt>
                <c:pt idx="16">
                  <c:v>0.1</c:v>
                </c:pt>
                <c:pt idx="17">
                  <c:v>-0.2</c:v>
                </c:pt>
                <c:pt idx="18">
                  <c:v>0.3</c:v>
                </c:pt>
                <c:pt idx="19">
                  <c:v>0.1</c:v>
                </c:pt>
                <c:pt idx="20">
                  <c:v>0.1</c:v>
                </c:pt>
                <c:pt idx="21">
                  <c:v>0.15</c:v>
                </c:pt>
                <c:pt idx="22">
                  <c:v>0.2</c:v>
                </c:pt>
                <c:pt idx="23">
                  <c:v>0</c:v>
                </c:pt>
                <c:pt idx="24">
                  <c:v>0.3</c:v>
                </c:pt>
                <c:pt idx="25">
                  <c:v>0.05</c:v>
                </c:pt>
                <c:pt idx="26">
                  <c:v>-0.1</c:v>
                </c:pt>
              </c:numCache>
            </c:numRef>
          </c:xVal>
          <c:yVal>
            <c:numRef>
              <c:f>文字数と視力!$J$2:$J$59</c:f>
              <c:numCache>
                <c:formatCode>0.0_);[Red]\(0.0\)</c:formatCode>
                <c:ptCount val="58"/>
                <c:pt idx="0">
                  <c:v>1520.1384820858652</c:v>
                </c:pt>
                <c:pt idx="1">
                  <c:v>1413.5772958542475</c:v>
                </c:pt>
                <c:pt idx="2">
                  <c:v>1413.5772958542475</c:v>
                </c:pt>
                <c:pt idx="3">
                  <c:v>1899.9922958697773</c:v>
                </c:pt>
                <c:pt idx="4">
                  <c:v>1413.5772958542475</c:v>
                </c:pt>
                <c:pt idx="5">
                  <c:v>1779.9720906125983</c:v>
                </c:pt>
                <c:pt idx="6">
                  <c:v>1520.1384820858652</c:v>
                </c:pt>
                <c:pt idx="7">
                  <c:v>1520.1384820858652</c:v>
                </c:pt>
                <c:pt idx="8">
                  <c:v>1413.5772958542475</c:v>
                </c:pt>
                <c:pt idx="9">
                  <c:v>1520.1384820858652</c:v>
                </c:pt>
                <c:pt idx="10">
                  <c:v>1413.5772958542475</c:v>
                </c:pt>
                <c:pt idx="11">
                  <c:v>1413.5772958542475</c:v>
                </c:pt>
                <c:pt idx="12">
                  <c:v>1675.4801172250095</c:v>
                </c:pt>
                <c:pt idx="13">
                  <c:v>1779.9720906125983</c:v>
                </c:pt>
                <c:pt idx="14">
                  <c:v>1675.4801172250095</c:v>
                </c:pt>
                <c:pt idx="15">
                  <c:v>1675.4801172250095</c:v>
                </c:pt>
                <c:pt idx="16">
                  <c:v>1899.9922958697773</c:v>
                </c:pt>
                <c:pt idx="17">
                  <c:v>2747.8534520544672</c:v>
                </c:pt>
                <c:pt idx="18">
                  <c:v>1520.1384820858652</c:v>
                </c:pt>
                <c:pt idx="19">
                  <c:v>1899.9922958697773</c:v>
                </c:pt>
                <c:pt idx="20">
                  <c:v>1899.9922958697773</c:v>
                </c:pt>
                <c:pt idx="21">
                  <c:v>1779.9720906125983</c:v>
                </c:pt>
                <c:pt idx="22">
                  <c:v>1675.4801172250095</c:v>
                </c:pt>
                <c:pt idx="23">
                  <c:v>2168.1995326069027</c:v>
                </c:pt>
                <c:pt idx="24">
                  <c:v>1520.1384820858652</c:v>
                </c:pt>
                <c:pt idx="25">
                  <c:v>2030.7207867355185</c:v>
                </c:pt>
                <c:pt idx="26">
                  <c:v>2454.27298477670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2F8-4464-9A15-F5235C605C9F}"/>
            </c:ext>
          </c:extLst>
        </c:ser>
        <c:ser>
          <c:idx val="4"/>
          <c:order val="4"/>
          <c:tx>
            <c:v>C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力!$A$2:$A$59</c:f>
              <c:numCache>
                <c:formatCode>General</c:formatCode>
                <c:ptCount val="58"/>
                <c:pt idx="0">
                  <c:v>0.3</c:v>
                </c:pt>
                <c:pt idx="1">
                  <c:v>0.4</c:v>
                </c:pt>
                <c:pt idx="2">
                  <c:v>0.4</c:v>
                </c:pt>
                <c:pt idx="3">
                  <c:v>0.1</c:v>
                </c:pt>
                <c:pt idx="4">
                  <c:v>0.4</c:v>
                </c:pt>
                <c:pt idx="5">
                  <c:v>0.15</c:v>
                </c:pt>
                <c:pt idx="6">
                  <c:v>0.3</c:v>
                </c:pt>
                <c:pt idx="7">
                  <c:v>0.3</c:v>
                </c:pt>
                <c:pt idx="8">
                  <c:v>0.4</c:v>
                </c:pt>
                <c:pt idx="9">
                  <c:v>0.3</c:v>
                </c:pt>
                <c:pt idx="10">
                  <c:v>0.4</c:v>
                </c:pt>
                <c:pt idx="11">
                  <c:v>0.4</c:v>
                </c:pt>
                <c:pt idx="12">
                  <c:v>0.2</c:v>
                </c:pt>
                <c:pt idx="13">
                  <c:v>0.15</c:v>
                </c:pt>
                <c:pt idx="14">
                  <c:v>0.2</c:v>
                </c:pt>
                <c:pt idx="15">
                  <c:v>0.2</c:v>
                </c:pt>
                <c:pt idx="16">
                  <c:v>0.1</c:v>
                </c:pt>
                <c:pt idx="17">
                  <c:v>-0.2</c:v>
                </c:pt>
                <c:pt idx="18">
                  <c:v>0.3</c:v>
                </c:pt>
                <c:pt idx="19">
                  <c:v>0.1</c:v>
                </c:pt>
                <c:pt idx="20">
                  <c:v>0.1</c:v>
                </c:pt>
                <c:pt idx="21">
                  <c:v>0.15</c:v>
                </c:pt>
                <c:pt idx="22">
                  <c:v>0.2</c:v>
                </c:pt>
                <c:pt idx="23">
                  <c:v>0</c:v>
                </c:pt>
                <c:pt idx="24">
                  <c:v>0.3</c:v>
                </c:pt>
                <c:pt idx="25">
                  <c:v>0.05</c:v>
                </c:pt>
                <c:pt idx="26">
                  <c:v>-0.1</c:v>
                </c:pt>
              </c:numCache>
            </c:numRef>
          </c:xVal>
          <c:yVal>
            <c:numRef>
              <c:f>文字数と視力!$K$2:$K$59</c:f>
              <c:numCache>
                <c:formatCode>0.0_);[Red]\(0.0\)</c:formatCode>
                <c:ptCount val="58"/>
                <c:pt idx="0">
                  <c:v>1090.0859273629535</c:v>
                </c:pt>
                <c:pt idx="1">
                  <c:v>826.2494757992954</c:v>
                </c:pt>
                <c:pt idx="2">
                  <c:v>826.2494757992954</c:v>
                </c:pt>
                <c:pt idx="3">
                  <c:v>1451.0273891695927</c:v>
                </c:pt>
                <c:pt idx="4">
                  <c:v>826.2494757992954</c:v>
                </c:pt>
                <c:pt idx="5">
                  <c:v>1385.8487755291337</c:v>
                </c:pt>
                <c:pt idx="6">
                  <c:v>1090.0859273629535</c:v>
                </c:pt>
                <c:pt idx="7">
                  <c:v>1090.0859273629535</c:v>
                </c:pt>
                <c:pt idx="8">
                  <c:v>826.2494757992954</c:v>
                </c:pt>
                <c:pt idx="9">
                  <c:v>1090.0859273629535</c:v>
                </c:pt>
                <c:pt idx="10">
                  <c:v>826.2494757992954</c:v>
                </c:pt>
                <c:pt idx="11">
                  <c:v>826.2494757992954</c:v>
                </c:pt>
                <c:pt idx="12">
                  <c:v>1305.1419300190846</c:v>
                </c:pt>
                <c:pt idx="13">
                  <c:v>1385.8487755291337</c:v>
                </c:pt>
                <c:pt idx="14">
                  <c:v>1305.1419300190846</c:v>
                </c:pt>
                <c:pt idx="15">
                  <c:v>1305.1419300190846</c:v>
                </c:pt>
                <c:pt idx="16">
                  <c:v>1451.0273891695927</c:v>
                </c:pt>
                <c:pt idx="17">
                  <c:v>1714.3591463707289</c:v>
                </c:pt>
                <c:pt idx="18">
                  <c:v>1090.0859273629535</c:v>
                </c:pt>
                <c:pt idx="19">
                  <c:v>1451.0273891695927</c:v>
                </c:pt>
                <c:pt idx="20">
                  <c:v>1451.0273891695927</c:v>
                </c:pt>
                <c:pt idx="21">
                  <c:v>1385.8487755291337</c:v>
                </c:pt>
                <c:pt idx="22">
                  <c:v>1305.1419300190846</c:v>
                </c:pt>
                <c:pt idx="23">
                  <c:v>1553.2177902277426</c:v>
                </c:pt>
                <c:pt idx="24">
                  <c:v>1090.0859273629535</c:v>
                </c:pt>
                <c:pt idx="25">
                  <c:v>1505.497717201489</c:v>
                </c:pt>
                <c:pt idx="26">
                  <c:v>1637.54197585321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92F8-4464-9A15-F5235C605C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5222416"/>
        <c:axId val="865216840"/>
      </c:scatterChart>
      <c:valAx>
        <c:axId val="8652224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Acuity (</a:t>
                </a:r>
                <a:r>
                  <a:rPr lang="en-US" dirty="0" err="1"/>
                  <a:t>LogMAR</a:t>
                </a:r>
                <a:r>
                  <a:rPr lang="en-US" dirty="0"/>
                  <a:t>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40042757167489107"/>
              <c:y val="0.856537565799532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16840"/>
        <c:crossesAt val="-1000"/>
        <c:crossBetween val="midCat"/>
      </c:valAx>
      <c:valAx>
        <c:axId val="865216840"/>
        <c:scaling>
          <c:orientation val="minMax"/>
          <c:max val="4000"/>
          <c:min val="-100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letter correctly read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1.3094649189215825E-2"/>
              <c:y val="7.104574842190332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22416"/>
        <c:crossesAt val="-40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809285939700701"/>
          <c:y val="5.091761042232823E-2"/>
          <c:w val="0.70964639836687082"/>
          <c:h val="0.70887252641687126"/>
        </c:manualLayout>
      </c:layout>
      <c:scatterChart>
        <c:scatterStyle val="lineMarker"/>
        <c:varyColors val="0"/>
        <c:ser>
          <c:idx val="0"/>
          <c:order val="0"/>
          <c:tx>
            <c:strRef>
              <c:f>文字数と視野角!$B$1</c:f>
              <c:strCache>
                <c:ptCount val="1"/>
                <c:pt idx="0">
                  <c:v>Number of letter correctly rea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6.3940387987442934E-2"/>
                  <c:y val="0.2948890027963164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dirty="0"/>
                      <a:t>y = 54.249x + 1028</a:t>
                    </a:r>
                  </a:p>
                  <a:p>
                    <a:pPr>
                      <a:defRPr lang="ja-JP"/>
                    </a:pPr>
                    <a:r>
                      <a:rPr lang="en-US" dirty="0"/>
                      <a:t>   r = 0.514 ( p &lt;0.01)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文字数と視野角!$A$2:$A$59</c:f>
              <c:numCache>
                <c:formatCode>0.0_);[Red]\(0.0\)</c:formatCode>
                <c:ptCount val="58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文字数と視野角!$B$2:$B$59</c:f>
              <c:numCache>
                <c:formatCode>General</c:formatCode>
                <c:ptCount val="58"/>
                <c:pt idx="0">
                  <c:v>537</c:v>
                </c:pt>
                <c:pt idx="1">
                  <c:v>484</c:v>
                </c:pt>
                <c:pt idx="2">
                  <c:v>1155</c:v>
                </c:pt>
                <c:pt idx="3">
                  <c:v>1509</c:v>
                </c:pt>
                <c:pt idx="4">
                  <c:v>1154</c:v>
                </c:pt>
                <c:pt idx="5">
                  <c:v>1160</c:v>
                </c:pt>
                <c:pt idx="6">
                  <c:v>808</c:v>
                </c:pt>
                <c:pt idx="7">
                  <c:v>1246</c:v>
                </c:pt>
                <c:pt idx="8">
                  <c:v>1185</c:v>
                </c:pt>
                <c:pt idx="9">
                  <c:v>1531</c:v>
                </c:pt>
                <c:pt idx="10">
                  <c:v>766</c:v>
                </c:pt>
                <c:pt idx="11">
                  <c:v>882</c:v>
                </c:pt>
                <c:pt idx="12">
                  <c:v>2841</c:v>
                </c:pt>
                <c:pt idx="13">
                  <c:v>2277</c:v>
                </c:pt>
                <c:pt idx="14">
                  <c:v>1875</c:v>
                </c:pt>
                <c:pt idx="15">
                  <c:v>1483</c:v>
                </c:pt>
                <c:pt idx="16">
                  <c:v>1264</c:v>
                </c:pt>
                <c:pt idx="17">
                  <c:v>1688</c:v>
                </c:pt>
                <c:pt idx="18">
                  <c:v>1350</c:v>
                </c:pt>
                <c:pt idx="19">
                  <c:v>1723</c:v>
                </c:pt>
                <c:pt idx="20">
                  <c:v>2199</c:v>
                </c:pt>
                <c:pt idx="21">
                  <c:v>1803</c:v>
                </c:pt>
                <c:pt idx="22">
                  <c:v>1811</c:v>
                </c:pt>
                <c:pt idx="23">
                  <c:v>1826</c:v>
                </c:pt>
                <c:pt idx="24">
                  <c:v>1866</c:v>
                </c:pt>
                <c:pt idx="25">
                  <c:v>1481</c:v>
                </c:pt>
                <c:pt idx="26">
                  <c:v>19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3A2-4CF6-ACDF-57E8970A6701}"/>
            </c:ext>
          </c:extLst>
        </c:ser>
        <c:ser>
          <c:idx val="1"/>
          <c:order val="1"/>
          <c:tx>
            <c:v>P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野角!$A$2:$A$59</c:f>
              <c:numCache>
                <c:formatCode>0.0_);[Red]\(0.0\)</c:formatCode>
                <c:ptCount val="58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文字数と視野角!$F$2:$F$59</c:f>
              <c:numCache>
                <c:formatCode>0.0_);[Red]\(0.0\)</c:formatCode>
                <c:ptCount val="58"/>
                <c:pt idx="0">
                  <c:v>2207.7636021420476</c:v>
                </c:pt>
                <c:pt idx="1">
                  <c:v>2207.7636021420476</c:v>
                </c:pt>
                <c:pt idx="2">
                  <c:v>2184.400928999311</c:v>
                </c:pt>
                <c:pt idx="3">
                  <c:v>2255.476747755511</c:v>
                </c:pt>
                <c:pt idx="4">
                  <c:v>2255.476747755511</c:v>
                </c:pt>
                <c:pt idx="5">
                  <c:v>2279.8336240783838</c:v>
                </c:pt>
                <c:pt idx="6">
                  <c:v>2207.7636021420476</c:v>
                </c:pt>
                <c:pt idx="7">
                  <c:v>2255.476747755511</c:v>
                </c:pt>
                <c:pt idx="8">
                  <c:v>2279.8336240783838</c:v>
                </c:pt>
                <c:pt idx="9">
                  <c:v>2304.5278180622486</c:v>
                </c:pt>
                <c:pt idx="10">
                  <c:v>2354.937637241328</c:v>
                </c:pt>
                <c:pt idx="11">
                  <c:v>2354.937637241328</c:v>
                </c:pt>
                <c:pt idx="12">
                  <c:v>2406.721863993168</c:v>
                </c:pt>
                <c:pt idx="13">
                  <c:v>2406.721863993168</c:v>
                </c:pt>
                <c:pt idx="14">
                  <c:v>2406.721863993168</c:v>
                </c:pt>
                <c:pt idx="15">
                  <c:v>2406.721863993168</c:v>
                </c:pt>
                <c:pt idx="16">
                  <c:v>2406.721863993168</c:v>
                </c:pt>
                <c:pt idx="17">
                  <c:v>2459.8906782850963</c:v>
                </c:pt>
                <c:pt idx="18">
                  <c:v>2570.3942630681913</c:v>
                </c:pt>
                <c:pt idx="19">
                  <c:v>2570.3942630681913</c:v>
                </c:pt>
                <c:pt idx="20">
                  <c:v>2686.4152613785914</c:v>
                </c:pt>
                <c:pt idx="21">
                  <c:v>2807.8317007608057</c:v>
                </c:pt>
                <c:pt idx="22">
                  <c:v>2870.5030400327032</c:v>
                </c:pt>
                <c:pt idx="23">
                  <c:v>2870.5030400327032</c:v>
                </c:pt>
                <c:pt idx="24">
                  <c:v>2870.5030400327032</c:v>
                </c:pt>
                <c:pt idx="25">
                  <c:v>3202.136388843016</c:v>
                </c:pt>
                <c:pt idx="26">
                  <c:v>3202.1363888430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3A2-4CF6-ACDF-57E8970A6701}"/>
            </c:ext>
          </c:extLst>
        </c:ser>
        <c:ser>
          <c:idx val="2"/>
          <c:order val="2"/>
          <c:tx>
            <c:v>P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野角!$A$2:$A$59</c:f>
              <c:numCache>
                <c:formatCode>0.0_);[Red]\(0.0\)</c:formatCode>
                <c:ptCount val="58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文字数と視野角!$G$2:$G$59</c:f>
              <c:numCache>
                <c:formatCode>0.0_);[Red]\(0.0\)</c:formatCode>
                <c:ptCount val="58"/>
                <c:pt idx="0">
                  <c:v>172.79200688372464</c:v>
                </c:pt>
                <c:pt idx="1">
                  <c:v>172.79200688372464</c:v>
                </c:pt>
                <c:pt idx="2">
                  <c:v>141.90556228504317</c:v>
                </c:pt>
                <c:pt idx="3">
                  <c:v>233.57709675309763</c:v>
                </c:pt>
                <c:pt idx="4">
                  <c:v>233.57709675309763</c:v>
                </c:pt>
                <c:pt idx="5">
                  <c:v>263.46933817164268</c:v>
                </c:pt>
                <c:pt idx="6">
                  <c:v>172.79200688372464</c:v>
                </c:pt>
                <c:pt idx="7">
                  <c:v>233.57709675309763</c:v>
                </c:pt>
                <c:pt idx="8">
                  <c:v>263.46933817164268</c:v>
                </c:pt>
                <c:pt idx="9">
                  <c:v>293.02426192919609</c:v>
                </c:pt>
                <c:pt idx="10">
                  <c:v>351.11267823295316</c:v>
                </c:pt>
                <c:pt idx="11">
                  <c:v>351.11267823295316</c:v>
                </c:pt>
                <c:pt idx="12">
                  <c:v>407.82668696394887</c:v>
                </c:pt>
                <c:pt idx="13">
                  <c:v>407.82668696394887</c:v>
                </c:pt>
                <c:pt idx="14">
                  <c:v>407.82668696394887</c:v>
                </c:pt>
                <c:pt idx="15">
                  <c:v>407.82668696394887</c:v>
                </c:pt>
                <c:pt idx="16">
                  <c:v>407.82668696394887</c:v>
                </c:pt>
                <c:pt idx="17">
                  <c:v>463.15610815485684</c:v>
                </c:pt>
                <c:pt idx="18">
                  <c:v>569.64899433743335</c:v>
                </c:pt>
                <c:pt idx="19">
                  <c:v>569.64899433743335</c:v>
                </c:pt>
                <c:pt idx="20">
                  <c:v>670.62446699270606</c:v>
                </c:pt>
                <c:pt idx="21">
                  <c:v>766.20449857616416</c:v>
                </c:pt>
                <c:pt idx="22">
                  <c:v>812.03139478710227</c:v>
                </c:pt>
                <c:pt idx="23">
                  <c:v>812.03139478710227</c:v>
                </c:pt>
                <c:pt idx="24">
                  <c:v>812.03139478710227</c:v>
                </c:pt>
                <c:pt idx="25">
                  <c:v>1022.8892233909703</c:v>
                </c:pt>
                <c:pt idx="26">
                  <c:v>1022.88922339097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3A2-4CF6-ACDF-57E8970A6701}"/>
            </c:ext>
          </c:extLst>
        </c:ser>
        <c:ser>
          <c:idx val="3"/>
          <c:order val="3"/>
          <c:tx>
            <c:v>C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野角!$A$2:$A$59</c:f>
              <c:numCache>
                <c:formatCode>0.0_);[Red]\(0.0\)</c:formatCode>
                <c:ptCount val="58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文字数と視野角!$J$2:$J$59</c:f>
              <c:numCache>
                <c:formatCode>0.0_);[Red]\(0.0\)</c:formatCode>
                <c:ptCount val="58"/>
                <c:pt idx="0">
                  <c:v>1462.7500110909177</c:v>
                </c:pt>
                <c:pt idx="1">
                  <c:v>1462.7500110909177</c:v>
                </c:pt>
                <c:pt idx="2">
                  <c:v>1449.3535002590511</c:v>
                </c:pt>
                <c:pt idx="3">
                  <c:v>1491.4749019208132</c:v>
                </c:pt>
                <c:pt idx="4">
                  <c:v>1491.4749019208132</c:v>
                </c:pt>
                <c:pt idx="5">
                  <c:v>1507.0128805738211</c:v>
                </c:pt>
                <c:pt idx="6">
                  <c:v>1462.7500110909177</c:v>
                </c:pt>
                <c:pt idx="7">
                  <c:v>1491.4749019208132</c:v>
                </c:pt>
                <c:pt idx="8">
                  <c:v>1507.0128805738211</c:v>
                </c:pt>
                <c:pt idx="9">
                  <c:v>1523.4989673183024</c:v>
                </c:pt>
                <c:pt idx="10">
                  <c:v>1559.8883288592108</c:v>
                </c:pt>
                <c:pt idx="11">
                  <c:v>1559.8883288592108</c:v>
                </c:pt>
                <c:pt idx="12">
                  <c:v>1601.8487783511562</c:v>
                </c:pt>
                <c:pt idx="13">
                  <c:v>1601.8487783511562</c:v>
                </c:pt>
                <c:pt idx="14">
                  <c:v>1601.8487783511562</c:v>
                </c:pt>
                <c:pt idx="15">
                  <c:v>1601.8487783511562</c:v>
                </c:pt>
                <c:pt idx="16">
                  <c:v>1601.8487783511562</c:v>
                </c:pt>
                <c:pt idx="17">
                  <c:v>1650.47045159546</c:v>
                </c:pt>
                <c:pt idx="18">
                  <c:v>1769.2932086322612</c:v>
                </c:pt>
                <c:pt idx="19">
                  <c:v>1769.2932086322612</c:v>
                </c:pt>
                <c:pt idx="20">
                  <c:v>1912.6499277468452</c:v>
                </c:pt>
                <c:pt idx="21">
                  <c:v>2071.6655362554357</c:v>
                </c:pt>
                <c:pt idx="22">
                  <c:v>2154.7797906035203</c:v>
                </c:pt>
                <c:pt idx="23">
                  <c:v>2154.7797906035203</c:v>
                </c:pt>
                <c:pt idx="24">
                  <c:v>2154.7797906035203</c:v>
                </c:pt>
                <c:pt idx="25">
                  <c:v>2588.163210314387</c:v>
                </c:pt>
                <c:pt idx="26">
                  <c:v>2588.1632103143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3A2-4CF6-ACDF-57E8970A6701}"/>
            </c:ext>
          </c:extLst>
        </c:ser>
        <c:ser>
          <c:idx val="4"/>
          <c:order val="4"/>
          <c:tx>
            <c:v>C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視野角!$A$2:$A$59</c:f>
              <c:numCache>
                <c:formatCode>0.0_);[Red]\(0.0\)</c:formatCode>
                <c:ptCount val="58"/>
                <c:pt idx="0">
                  <c:v>3</c:v>
                </c:pt>
                <c:pt idx="1">
                  <c:v>3</c:v>
                </c:pt>
                <c:pt idx="2">
                  <c:v>2.5</c:v>
                </c:pt>
                <c:pt idx="3">
                  <c:v>4</c:v>
                </c:pt>
                <c:pt idx="4">
                  <c:v>4</c:v>
                </c:pt>
                <c:pt idx="5">
                  <c:v>4.5</c:v>
                </c:pt>
                <c:pt idx="6">
                  <c:v>3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8</c:v>
                </c:pt>
                <c:pt idx="18">
                  <c:v>10</c:v>
                </c:pt>
                <c:pt idx="19">
                  <c:v>10</c:v>
                </c:pt>
                <c:pt idx="20">
                  <c:v>12</c:v>
                </c:pt>
                <c:pt idx="21">
                  <c:v>14</c:v>
                </c:pt>
                <c:pt idx="22">
                  <c:v>15</c:v>
                </c:pt>
                <c:pt idx="23">
                  <c:v>15</c:v>
                </c:pt>
                <c:pt idx="24">
                  <c:v>15</c:v>
                </c:pt>
                <c:pt idx="25">
                  <c:v>20</c:v>
                </c:pt>
                <c:pt idx="26">
                  <c:v>20</c:v>
                </c:pt>
              </c:numCache>
            </c:numRef>
          </c:xVal>
          <c:yVal>
            <c:numRef>
              <c:f>文字数と視野角!$K$2:$K$59</c:f>
              <c:numCache>
                <c:formatCode>0.0_);[Red]\(0.0\)</c:formatCode>
                <c:ptCount val="58"/>
                <c:pt idx="0">
                  <c:v>917.80559793485452</c:v>
                </c:pt>
                <c:pt idx="1">
                  <c:v>917.80559793485452</c:v>
                </c:pt>
                <c:pt idx="2">
                  <c:v>876.95299102530316</c:v>
                </c:pt>
                <c:pt idx="3">
                  <c:v>997.57894258779538</c:v>
                </c:pt>
                <c:pt idx="4">
                  <c:v>997.57894258779538</c:v>
                </c:pt>
                <c:pt idx="5">
                  <c:v>1036.2900816762055</c:v>
                </c:pt>
                <c:pt idx="6">
                  <c:v>917.80559793485452</c:v>
                </c:pt>
                <c:pt idx="7">
                  <c:v>997.57894258779538</c:v>
                </c:pt>
                <c:pt idx="8">
                  <c:v>1036.2900816762055</c:v>
                </c:pt>
                <c:pt idx="9">
                  <c:v>1074.0531126731423</c:v>
                </c:pt>
                <c:pt idx="10">
                  <c:v>1146.1619866150702</c:v>
                </c:pt>
                <c:pt idx="11">
                  <c:v>1146.1619866150702</c:v>
                </c:pt>
                <c:pt idx="12">
                  <c:v>1212.6997726059606</c:v>
                </c:pt>
                <c:pt idx="13">
                  <c:v>1212.6997726059606</c:v>
                </c:pt>
                <c:pt idx="14">
                  <c:v>1212.6997726059606</c:v>
                </c:pt>
                <c:pt idx="15">
                  <c:v>1212.6997726059606</c:v>
                </c:pt>
                <c:pt idx="16">
                  <c:v>1212.6997726059606</c:v>
                </c:pt>
                <c:pt idx="17">
                  <c:v>1272.576334844493</c:v>
                </c:pt>
                <c:pt idx="18">
                  <c:v>1370.7500487733637</c:v>
                </c:pt>
                <c:pt idx="19">
                  <c:v>1370.7500487733637</c:v>
                </c:pt>
                <c:pt idx="20">
                  <c:v>1444.3898006244522</c:v>
                </c:pt>
                <c:pt idx="21">
                  <c:v>1502.3706630815343</c:v>
                </c:pt>
                <c:pt idx="22">
                  <c:v>1527.754644216285</c:v>
                </c:pt>
                <c:pt idx="23">
                  <c:v>1527.754644216285</c:v>
                </c:pt>
                <c:pt idx="24">
                  <c:v>1527.754644216285</c:v>
                </c:pt>
                <c:pt idx="25">
                  <c:v>1636.8624019195991</c:v>
                </c:pt>
                <c:pt idx="26">
                  <c:v>1636.86240191959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53A2-4CF6-ACDF-57E8970A67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5222416"/>
        <c:axId val="865216840"/>
      </c:scatterChart>
      <c:valAx>
        <c:axId val="865222416"/>
        <c:scaling>
          <c:orientation val="minMax"/>
          <c:max val="25"/>
          <c:min val="0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I/</a:t>
                </a:r>
                <a:r>
                  <a:rPr lang="ja-JP" dirty="0"/>
                  <a:t>４</a:t>
                </a:r>
                <a:r>
                  <a:rPr lang="en-US" dirty="0"/>
                  <a:t>central  (degree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36713591278203939"/>
              <c:y val="0.858396849729060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.0_);[Red]\(0.0\)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16840"/>
        <c:crossesAt val="-1000"/>
        <c:crossBetween val="midCat"/>
      </c:valAx>
      <c:valAx>
        <c:axId val="865216840"/>
        <c:scaling>
          <c:orientation val="minMax"/>
          <c:max val="4000"/>
          <c:min val="-100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letter correctly read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4.0071350439184625E-2"/>
              <c:y val="6.391595146533796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22416"/>
        <c:crossesAt val="-40"/>
        <c:crossBetween val="midCat"/>
        <c:majorUnit val="10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126274309387712"/>
          <c:y val="5.091761042232823E-2"/>
          <c:w val="0.71071574481945821"/>
          <c:h val="0.7512680780404366"/>
        </c:manualLayout>
      </c:layout>
      <c:scatterChart>
        <c:scatterStyle val="lineMarker"/>
        <c:varyColors val="0"/>
        <c:ser>
          <c:idx val="0"/>
          <c:order val="0"/>
          <c:tx>
            <c:strRef>
              <c:f>文字数と傍中心!$B$1</c:f>
              <c:strCache>
                <c:ptCount val="1"/>
                <c:pt idx="0">
                  <c:v>Number of letter correctly rea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-7.5616531935233891E-2"/>
                  <c:y val="0.26808171735730879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dirty="0"/>
                      <a:t>y = 486.18x + 1214</a:t>
                    </a:r>
                  </a:p>
                  <a:p>
                    <a:pPr>
                      <a:defRPr lang="ja-JP"/>
                    </a:pPr>
                    <a:r>
                      <a:rPr lang="en-US" dirty="0"/>
                      <a:t>  r = 0.384 ( p &lt; 0.05)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文字数と傍中心!$A$2:$A$59</c:f>
              <c:numCache>
                <c:formatCode>0%</c:formatCode>
                <c:ptCount val="58"/>
                <c:pt idx="0">
                  <c:v>0.01</c:v>
                </c:pt>
                <c:pt idx="1">
                  <c:v>0</c:v>
                </c:pt>
                <c:pt idx="2">
                  <c:v>0.13</c:v>
                </c:pt>
                <c:pt idx="3">
                  <c:v>0</c:v>
                </c:pt>
                <c:pt idx="4">
                  <c:v>0.46</c:v>
                </c:pt>
                <c:pt idx="5">
                  <c:v>0.71</c:v>
                </c:pt>
                <c:pt idx="6">
                  <c:v>0.17</c:v>
                </c:pt>
                <c:pt idx="7">
                  <c:v>1</c:v>
                </c:pt>
                <c:pt idx="8">
                  <c:v>0.08</c:v>
                </c:pt>
                <c:pt idx="9">
                  <c:v>0.25</c:v>
                </c:pt>
                <c:pt idx="10">
                  <c:v>0</c:v>
                </c:pt>
                <c:pt idx="11">
                  <c:v>0.96</c:v>
                </c:pt>
                <c:pt idx="12">
                  <c:v>0.96</c:v>
                </c:pt>
                <c:pt idx="13">
                  <c:v>0.04</c:v>
                </c:pt>
                <c:pt idx="14">
                  <c:v>0.17</c:v>
                </c:pt>
                <c:pt idx="15">
                  <c:v>0</c:v>
                </c:pt>
                <c:pt idx="16">
                  <c:v>0.96</c:v>
                </c:pt>
                <c:pt idx="17">
                  <c:v>0.96</c:v>
                </c:pt>
                <c:pt idx="18">
                  <c:v>0.5</c:v>
                </c:pt>
                <c:pt idx="19">
                  <c:v>0.92</c:v>
                </c:pt>
                <c:pt idx="20">
                  <c:v>0.33</c:v>
                </c:pt>
                <c:pt idx="21">
                  <c:v>0.96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</c:numCache>
            </c:numRef>
          </c:xVal>
          <c:yVal>
            <c:numRef>
              <c:f>文字数と傍中心!$B$2:$B$59</c:f>
              <c:numCache>
                <c:formatCode>General</c:formatCode>
                <c:ptCount val="58"/>
                <c:pt idx="0">
                  <c:v>537</c:v>
                </c:pt>
                <c:pt idx="1">
                  <c:v>484</c:v>
                </c:pt>
                <c:pt idx="2">
                  <c:v>1155</c:v>
                </c:pt>
                <c:pt idx="3">
                  <c:v>1509</c:v>
                </c:pt>
                <c:pt idx="4">
                  <c:v>1154</c:v>
                </c:pt>
                <c:pt idx="5">
                  <c:v>1160</c:v>
                </c:pt>
                <c:pt idx="6">
                  <c:v>808</c:v>
                </c:pt>
                <c:pt idx="7">
                  <c:v>1246</c:v>
                </c:pt>
                <c:pt idx="8">
                  <c:v>1185</c:v>
                </c:pt>
                <c:pt idx="9">
                  <c:v>1531</c:v>
                </c:pt>
                <c:pt idx="10">
                  <c:v>766</c:v>
                </c:pt>
                <c:pt idx="11">
                  <c:v>882</c:v>
                </c:pt>
                <c:pt idx="12">
                  <c:v>2841</c:v>
                </c:pt>
                <c:pt idx="13">
                  <c:v>2277</c:v>
                </c:pt>
                <c:pt idx="14">
                  <c:v>1875</c:v>
                </c:pt>
                <c:pt idx="15">
                  <c:v>1483</c:v>
                </c:pt>
                <c:pt idx="16">
                  <c:v>1264</c:v>
                </c:pt>
                <c:pt idx="17">
                  <c:v>1688</c:v>
                </c:pt>
                <c:pt idx="18">
                  <c:v>1350</c:v>
                </c:pt>
                <c:pt idx="19">
                  <c:v>1723</c:v>
                </c:pt>
                <c:pt idx="20">
                  <c:v>2199</c:v>
                </c:pt>
                <c:pt idx="21">
                  <c:v>1803</c:v>
                </c:pt>
                <c:pt idx="22">
                  <c:v>1811</c:v>
                </c:pt>
                <c:pt idx="23">
                  <c:v>1826</c:v>
                </c:pt>
                <c:pt idx="24">
                  <c:v>1866</c:v>
                </c:pt>
                <c:pt idx="25">
                  <c:v>1481</c:v>
                </c:pt>
                <c:pt idx="26">
                  <c:v>19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C05-445C-8838-9916C21A81FB}"/>
            </c:ext>
          </c:extLst>
        </c:ser>
        <c:ser>
          <c:idx val="1"/>
          <c:order val="1"/>
          <c:tx>
            <c:v>P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傍中心!$A$2:$A$59</c:f>
              <c:numCache>
                <c:formatCode>0%</c:formatCode>
                <c:ptCount val="58"/>
                <c:pt idx="0">
                  <c:v>0.01</c:v>
                </c:pt>
                <c:pt idx="1">
                  <c:v>0</c:v>
                </c:pt>
                <c:pt idx="2">
                  <c:v>0.13</c:v>
                </c:pt>
                <c:pt idx="3">
                  <c:v>0</c:v>
                </c:pt>
                <c:pt idx="4">
                  <c:v>0.46</c:v>
                </c:pt>
                <c:pt idx="5">
                  <c:v>0.71</c:v>
                </c:pt>
                <c:pt idx="6">
                  <c:v>0.17</c:v>
                </c:pt>
                <c:pt idx="7">
                  <c:v>1</c:v>
                </c:pt>
                <c:pt idx="8">
                  <c:v>0.08</c:v>
                </c:pt>
                <c:pt idx="9">
                  <c:v>0.25</c:v>
                </c:pt>
                <c:pt idx="10">
                  <c:v>0</c:v>
                </c:pt>
                <c:pt idx="11">
                  <c:v>0.96</c:v>
                </c:pt>
                <c:pt idx="12">
                  <c:v>0.96</c:v>
                </c:pt>
                <c:pt idx="13">
                  <c:v>0.04</c:v>
                </c:pt>
                <c:pt idx="14">
                  <c:v>0.17</c:v>
                </c:pt>
                <c:pt idx="15">
                  <c:v>0</c:v>
                </c:pt>
                <c:pt idx="16">
                  <c:v>0.96</c:v>
                </c:pt>
                <c:pt idx="17">
                  <c:v>0.96</c:v>
                </c:pt>
                <c:pt idx="18">
                  <c:v>0.5</c:v>
                </c:pt>
                <c:pt idx="19">
                  <c:v>0.92</c:v>
                </c:pt>
                <c:pt idx="20">
                  <c:v>0.33</c:v>
                </c:pt>
                <c:pt idx="21">
                  <c:v>0.96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</c:numCache>
            </c:numRef>
          </c:xVal>
          <c:yVal>
            <c:numRef>
              <c:f>文字数と傍中心!$F$2:$F$59</c:f>
              <c:numCache>
                <c:formatCode>0.0_);[Red]\(0.0\)</c:formatCode>
                <c:ptCount val="58"/>
                <c:pt idx="0">
                  <c:v>2323.6846020341036</c:v>
                </c:pt>
                <c:pt idx="1">
                  <c:v>2319.9426649365059</c:v>
                </c:pt>
                <c:pt idx="2">
                  <c:v>2370.1518897796818</c:v>
                </c:pt>
                <c:pt idx="3">
                  <c:v>2319.9426649365059</c:v>
                </c:pt>
                <c:pt idx="4">
                  <c:v>2513.3535376530908</c:v>
                </c:pt>
                <c:pt idx="5">
                  <c:v>2637.3376645537555</c:v>
                </c:pt>
                <c:pt idx="6">
                  <c:v>2386.2924019071152</c:v>
                </c:pt>
                <c:pt idx="7">
                  <c:v>2797.7960512472473</c:v>
                </c:pt>
                <c:pt idx="8">
                  <c:v>2350.4370043930126</c:v>
                </c:pt>
                <c:pt idx="9">
                  <c:v>2419.5688789789906</c:v>
                </c:pt>
                <c:pt idx="10">
                  <c:v>2319.9426649365059</c:v>
                </c:pt>
                <c:pt idx="11">
                  <c:v>2774.6266044787453</c:v>
                </c:pt>
                <c:pt idx="12">
                  <c:v>2774.6266044787453</c:v>
                </c:pt>
                <c:pt idx="13">
                  <c:v>2335.0297021324695</c:v>
                </c:pt>
                <c:pt idx="14">
                  <c:v>2386.2924019071152</c:v>
                </c:pt>
                <c:pt idx="15">
                  <c:v>2319.9426649365059</c:v>
                </c:pt>
                <c:pt idx="16">
                  <c:v>2774.6266044787453</c:v>
                </c:pt>
                <c:pt idx="17">
                  <c:v>2774.6266044787453</c:v>
                </c:pt>
                <c:pt idx="18">
                  <c:v>2532.2872775349583</c:v>
                </c:pt>
                <c:pt idx="19">
                  <c:v>2751.7842244378053</c:v>
                </c:pt>
                <c:pt idx="20">
                  <c:v>2454.1893852371009</c:v>
                </c:pt>
                <c:pt idx="21">
                  <c:v>2774.6266044787453</c:v>
                </c:pt>
                <c:pt idx="22">
                  <c:v>2797.7960512472473</c:v>
                </c:pt>
                <c:pt idx="23">
                  <c:v>2797.7960512472473</c:v>
                </c:pt>
                <c:pt idx="24">
                  <c:v>2797.7960512472473</c:v>
                </c:pt>
                <c:pt idx="25">
                  <c:v>2797.7960512472473</c:v>
                </c:pt>
                <c:pt idx="26">
                  <c:v>2797.79605124724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C05-445C-8838-9916C21A81FB}"/>
            </c:ext>
          </c:extLst>
        </c:ser>
        <c:ser>
          <c:idx val="2"/>
          <c:order val="2"/>
          <c:tx>
            <c:v>P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傍中心!$A$2:$A$59</c:f>
              <c:numCache>
                <c:formatCode>0%</c:formatCode>
                <c:ptCount val="58"/>
                <c:pt idx="0">
                  <c:v>0.01</c:v>
                </c:pt>
                <c:pt idx="1">
                  <c:v>0</c:v>
                </c:pt>
                <c:pt idx="2">
                  <c:v>0.13</c:v>
                </c:pt>
                <c:pt idx="3">
                  <c:v>0</c:v>
                </c:pt>
                <c:pt idx="4">
                  <c:v>0.46</c:v>
                </c:pt>
                <c:pt idx="5">
                  <c:v>0.71</c:v>
                </c:pt>
                <c:pt idx="6">
                  <c:v>0.17</c:v>
                </c:pt>
                <c:pt idx="7">
                  <c:v>1</c:v>
                </c:pt>
                <c:pt idx="8">
                  <c:v>0.08</c:v>
                </c:pt>
                <c:pt idx="9">
                  <c:v>0.25</c:v>
                </c:pt>
                <c:pt idx="10">
                  <c:v>0</c:v>
                </c:pt>
                <c:pt idx="11">
                  <c:v>0.96</c:v>
                </c:pt>
                <c:pt idx="12">
                  <c:v>0.96</c:v>
                </c:pt>
                <c:pt idx="13">
                  <c:v>0.04</c:v>
                </c:pt>
                <c:pt idx="14">
                  <c:v>0.17</c:v>
                </c:pt>
                <c:pt idx="15">
                  <c:v>0</c:v>
                </c:pt>
                <c:pt idx="16">
                  <c:v>0.96</c:v>
                </c:pt>
                <c:pt idx="17">
                  <c:v>0.96</c:v>
                </c:pt>
                <c:pt idx="18">
                  <c:v>0.5</c:v>
                </c:pt>
                <c:pt idx="19">
                  <c:v>0.92</c:v>
                </c:pt>
                <c:pt idx="20">
                  <c:v>0.33</c:v>
                </c:pt>
                <c:pt idx="21">
                  <c:v>0.96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</c:numCache>
            </c:numRef>
          </c:xVal>
          <c:yVal>
            <c:numRef>
              <c:f>文字数と傍中心!$G$2:$G$59</c:f>
              <c:numCache>
                <c:formatCode>0.0_);[Red]\(0.0\)</c:formatCode>
                <c:ptCount val="58"/>
                <c:pt idx="0">
                  <c:v>114.50811478193532</c:v>
                </c:pt>
                <c:pt idx="1">
                  <c:v>108.52641786137451</c:v>
                </c:pt>
                <c:pt idx="2">
                  <c:v>184.72443525426161</c:v>
                </c:pt>
                <c:pt idx="3">
                  <c:v>108.52641786137451</c:v>
                </c:pt>
                <c:pt idx="4">
                  <c:v>362.40270998008964</c:v>
                </c:pt>
                <c:pt idx="5">
                  <c:v>481.50943353339244</c:v>
                </c:pt>
                <c:pt idx="6">
                  <c:v>207.47845919946303</c:v>
                </c:pt>
                <c:pt idx="7">
                  <c:v>603.03643336650362</c:v>
                </c:pt>
                <c:pt idx="8">
                  <c:v>155.82115055013719</c:v>
                </c:pt>
                <c:pt idx="9">
                  <c:v>251.99105427285713</c:v>
                </c:pt>
                <c:pt idx="10">
                  <c:v>108.52641786137451</c:v>
                </c:pt>
                <c:pt idx="11">
                  <c:v>587.31134406236993</c:v>
                </c:pt>
                <c:pt idx="12">
                  <c:v>587.31134406236993</c:v>
                </c:pt>
                <c:pt idx="13">
                  <c:v>132.33391673804522</c:v>
                </c:pt>
                <c:pt idx="14">
                  <c:v>207.47845919946303</c:v>
                </c:pt>
                <c:pt idx="15">
                  <c:v>108.52641786137451</c:v>
                </c:pt>
                <c:pt idx="16">
                  <c:v>587.31134406236993</c:v>
                </c:pt>
                <c:pt idx="17">
                  <c:v>587.31134406236993</c:v>
                </c:pt>
                <c:pt idx="18">
                  <c:v>382.36350617085691</c:v>
                </c:pt>
                <c:pt idx="19">
                  <c:v>571.2591880306752</c:v>
                </c:pt>
                <c:pt idx="20">
                  <c:v>295.1596201600164</c:v>
                </c:pt>
                <c:pt idx="21">
                  <c:v>587.31134406236993</c:v>
                </c:pt>
                <c:pt idx="22">
                  <c:v>603.03643336650362</c:v>
                </c:pt>
                <c:pt idx="23">
                  <c:v>603.03643336650362</c:v>
                </c:pt>
                <c:pt idx="24">
                  <c:v>603.03643336650362</c:v>
                </c:pt>
                <c:pt idx="25">
                  <c:v>603.03643336650362</c:v>
                </c:pt>
                <c:pt idx="26">
                  <c:v>603.036433366503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C05-445C-8838-9916C21A81FB}"/>
            </c:ext>
          </c:extLst>
        </c:ser>
        <c:ser>
          <c:idx val="3"/>
          <c:order val="3"/>
          <c:tx>
            <c:v>C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傍中心!$A$2:$A$59</c:f>
              <c:numCache>
                <c:formatCode>0%</c:formatCode>
                <c:ptCount val="58"/>
                <c:pt idx="0">
                  <c:v>0.01</c:v>
                </c:pt>
                <c:pt idx="1">
                  <c:v>0</c:v>
                </c:pt>
                <c:pt idx="2">
                  <c:v>0.13</c:v>
                </c:pt>
                <c:pt idx="3">
                  <c:v>0</c:v>
                </c:pt>
                <c:pt idx="4">
                  <c:v>0.46</c:v>
                </c:pt>
                <c:pt idx="5">
                  <c:v>0.71</c:v>
                </c:pt>
                <c:pt idx="6">
                  <c:v>0.17</c:v>
                </c:pt>
                <c:pt idx="7">
                  <c:v>1</c:v>
                </c:pt>
                <c:pt idx="8">
                  <c:v>0.08</c:v>
                </c:pt>
                <c:pt idx="9">
                  <c:v>0.25</c:v>
                </c:pt>
                <c:pt idx="10">
                  <c:v>0</c:v>
                </c:pt>
                <c:pt idx="11">
                  <c:v>0.96</c:v>
                </c:pt>
                <c:pt idx="12">
                  <c:v>0.96</c:v>
                </c:pt>
                <c:pt idx="13">
                  <c:v>0.04</c:v>
                </c:pt>
                <c:pt idx="14">
                  <c:v>0.17</c:v>
                </c:pt>
                <c:pt idx="15">
                  <c:v>0</c:v>
                </c:pt>
                <c:pt idx="16">
                  <c:v>0.96</c:v>
                </c:pt>
                <c:pt idx="17">
                  <c:v>0.96</c:v>
                </c:pt>
                <c:pt idx="18">
                  <c:v>0.5</c:v>
                </c:pt>
                <c:pt idx="19">
                  <c:v>0.92</c:v>
                </c:pt>
                <c:pt idx="20">
                  <c:v>0.33</c:v>
                </c:pt>
                <c:pt idx="21">
                  <c:v>0.96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</c:numCache>
            </c:numRef>
          </c:xVal>
          <c:yVal>
            <c:numRef>
              <c:f>文字数と傍中心!$J$2:$J$59</c:f>
              <c:numCache>
                <c:formatCode>0.0_);[Red]\(0.0\)</c:formatCode>
                <c:ptCount val="58"/>
                <c:pt idx="0">
                  <c:v>1544.9676599515485</c:v>
                </c:pt>
                <c:pt idx="1">
                  <c:v>1543.8818857984975</c:v>
                </c:pt>
                <c:pt idx="2">
                  <c:v>1560.4579621089445</c:v>
                </c:pt>
                <c:pt idx="3">
                  <c:v>1543.8818857984975</c:v>
                </c:pt>
                <c:pt idx="4">
                  <c:v>1644.5766554502438</c:v>
                </c:pt>
                <c:pt idx="5">
                  <c:v>1778.4572396685846</c:v>
                </c:pt>
                <c:pt idx="6">
                  <c:v>1566.8566631819381</c:v>
                </c:pt>
                <c:pt idx="7">
                  <c:v>2000.9480414275722</c:v>
                </c:pt>
                <c:pt idx="8">
                  <c:v>1553.3982961692955</c:v>
                </c:pt>
                <c:pt idx="9">
                  <c:v>1582.1035825302042</c:v>
                </c:pt>
                <c:pt idx="10">
                  <c:v>1543.8818857984975</c:v>
                </c:pt>
                <c:pt idx="11">
                  <c:v>1967.6114856419611</c:v>
                </c:pt>
                <c:pt idx="12">
                  <c:v>1967.6114856419611</c:v>
                </c:pt>
                <c:pt idx="13">
                  <c:v>1548.3945323450662</c:v>
                </c:pt>
                <c:pt idx="14">
                  <c:v>1566.8566631819381</c:v>
                </c:pt>
                <c:pt idx="15">
                  <c:v>1543.8818857984975</c:v>
                </c:pt>
                <c:pt idx="16">
                  <c:v>1967.6114856419611</c:v>
                </c:pt>
                <c:pt idx="17">
                  <c:v>1967.6114856419611</c:v>
                </c:pt>
                <c:pt idx="18">
                  <c:v>1661.3351290759779</c:v>
                </c:pt>
                <c:pt idx="19">
                  <c:v>1934.9248441319157</c:v>
                </c:pt>
                <c:pt idx="20">
                  <c:v>1601.4547902786717</c:v>
                </c:pt>
                <c:pt idx="21">
                  <c:v>1967.6114856419611</c:v>
                </c:pt>
                <c:pt idx="22">
                  <c:v>2000.9480414275722</c:v>
                </c:pt>
                <c:pt idx="23">
                  <c:v>2000.9480414275722</c:v>
                </c:pt>
                <c:pt idx="24">
                  <c:v>2000.9480414275722</c:v>
                </c:pt>
                <c:pt idx="25">
                  <c:v>2000.9480414275722</c:v>
                </c:pt>
                <c:pt idx="26">
                  <c:v>2000.94804142757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C05-445C-8838-9916C21A81FB}"/>
            </c:ext>
          </c:extLst>
        </c:ser>
        <c:ser>
          <c:idx val="4"/>
          <c:order val="4"/>
          <c:tx>
            <c:v>C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傍中心!$A$2:$A$59</c:f>
              <c:numCache>
                <c:formatCode>0%</c:formatCode>
                <c:ptCount val="58"/>
                <c:pt idx="0">
                  <c:v>0.01</c:v>
                </c:pt>
                <c:pt idx="1">
                  <c:v>0</c:v>
                </c:pt>
                <c:pt idx="2">
                  <c:v>0.13</c:v>
                </c:pt>
                <c:pt idx="3">
                  <c:v>0</c:v>
                </c:pt>
                <c:pt idx="4">
                  <c:v>0.46</c:v>
                </c:pt>
                <c:pt idx="5">
                  <c:v>0.71</c:v>
                </c:pt>
                <c:pt idx="6">
                  <c:v>0.17</c:v>
                </c:pt>
                <c:pt idx="7">
                  <c:v>1</c:v>
                </c:pt>
                <c:pt idx="8">
                  <c:v>0.08</c:v>
                </c:pt>
                <c:pt idx="9">
                  <c:v>0.25</c:v>
                </c:pt>
                <c:pt idx="10">
                  <c:v>0</c:v>
                </c:pt>
                <c:pt idx="11">
                  <c:v>0.96</c:v>
                </c:pt>
                <c:pt idx="12">
                  <c:v>0.96</c:v>
                </c:pt>
                <c:pt idx="13">
                  <c:v>0.04</c:v>
                </c:pt>
                <c:pt idx="14">
                  <c:v>0.17</c:v>
                </c:pt>
                <c:pt idx="15">
                  <c:v>0</c:v>
                </c:pt>
                <c:pt idx="16">
                  <c:v>0.96</c:v>
                </c:pt>
                <c:pt idx="17">
                  <c:v>0.96</c:v>
                </c:pt>
                <c:pt idx="18">
                  <c:v>0.5</c:v>
                </c:pt>
                <c:pt idx="19">
                  <c:v>0.92</c:v>
                </c:pt>
                <c:pt idx="20">
                  <c:v>0.33</c:v>
                </c:pt>
                <c:pt idx="21">
                  <c:v>0.96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</c:numCache>
            </c:numRef>
          </c:xVal>
          <c:yVal>
            <c:numRef>
              <c:f>文字数と傍中心!$K$2:$K$59</c:f>
              <c:numCache>
                <c:formatCode>0.0_);[Red]\(0.0\)</c:formatCode>
                <c:ptCount val="58"/>
                <c:pt idx="0">
                  <c:v>893.22505686449063</c:v>
                </c:pt>
                <c:pt idx="1">
                  <c:v>884.58719699938274</c:v>
                </c:pt>
                <c:pt idx="2">
                  <c:v>994.41836292499897</c:v>
                </c:pt>
                <c:pt idx="3">
                  <c:v>884.58719699938274</c:v>
                </c:pt>
                <c:pt idx="4">
                  <c:v>1231.1795921829366</c:v>
                </c:pt>
                <c:pt idx="5">
                  <c:v>1340.3898584185633</c:v>
                </c:pt>
                <c:pt idx="6">
                  <c:v>1026.9141979246401</c:v>
                </c:pt>
                <c:pt idx="7">
                  <c:v>1399.8844431861785</c:v>
                </c:pt>
                <c:pt idx="8">
                  <c:v>952.85985877385417</c:v>
                </c:pt>
                <c:pt idx="9">
                  <c:v>1089.4563507216435</c:v>
                </c:pt>
                <c:pt idx="10">
                  <c:v>884.58719699938274</c:v>
                </c:pt>
                <c:pt idx="11">
                  <c:v>1394.3264628991544</c:v>
                </c:pt>
                <c:pt idx="12">
                  <c:v>1394.3264628991544</c:v>
                </c:pt>
                <c:pt idx="13">
                  <c:v>918.9690865254488</c:v>
                </c:pt>
                <c:pt idx="14">
                  <c:v>1026.9141979246401</c:v>
                </c:pt>
                <c:pt idx="15">
                  <c:v>884.58719699938274</c:v>
                </c:pt>
                <c:pt idx="16">
                  <c:v>1394.3264628991544</c:v>
                </c:pt>
                <c:pt idx="17">
                  <c:v>1394.3264628991544</c:v>
                </c:pt>
                <c:pt idx="18">
                  <c:v>1253.3156546298374</c:v>
                </c:pt>
                <c:pt idx="19">
                  <c:v>1388.118568336565</c:v>
                </c:pt>
                <c:pt idx="20">
                  <c:v>1147.8942151184456</c:v>
                </c:pt>
                <c:pt idx="21">
                  <c:v>1394.3264628991544</c:v>
                </c:pt>
                <c:pt idx="22">
                  <c:v>1399.8844431861785</c:v>
                </c:pt>
                <c:pt idx="23">
                  <c:v>1399.8844431861785</c:v>
                </c:pt>
                <c:pt idx="24">
                  <c:v>1399.8844431861785</c:v>
                </c:pt>
                <c:pt idx="25">
                  <c:v>1399.8844431861785</c:v>
                </c:pt>
                <c:pt idx="26">
                  <c:v>1399.88444318617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3C05-445C-8838-9916C21A81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5222416"/>
        <c:axId val="865216840"/>
      </c:scatterChart>
      <c:valAx>
        <c:axId val="865222416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/>
                  <a:t>V/4 perifovea (%)</a:t>
                </a:r>
                <a:endParaRPr lang="ja-JP" altLang="en-US" dirty="0"/>
              </a:p>
            </c:rich>
          </c:tx>
          <c:layout>
            <c:manualLayout>
              <c:xMode val="edge"/>
              <c:yMode val="edge"/>
              <c:x val="0.42528948906493536"/>
              <c:y val="0.91964420644145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16840"/>
        <c:crossesAt val="-1000"/>
        <c:crossBetween val="midCat"/>
      </c:valAx>
      <c:valAx>
        <c:axId val="865216840"/>
        <c:scaling>
          <c:orientation val="minMax"/>
          <c:max val="4000"/>
          <c:min val="-100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letter correctly read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5.0878424116273732E-2"/>
              <c:y val="3.159761838489785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22416"/>
        <c:crossesAt val="-40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134283815361633"/>
          <c:y val="5.091761042232823E-2"/>
          <c:w val="0.75963905734716441"/>
          <c:h val="0.72321380606543184"/>
        </c:manualLayout>
      </c:layout>
      <c:scatterChart>
        <c:scatterStyle val="lineMarker"/>
        <c:varyColors val="0"/>
        <c:ser>
          <c:idx val="0"/>
          <c:order val="0"/>
          <c:tx>
            <c:strRef>
              <c:f>文字数と周辺視野!$B$1</c:f>
              <c:strCache>
                <c:ptCount val="1"/>
                <c:pt idx="0">
                  <c:v>Number of letter correctly read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7.8841793574009854E-3"/>
                  <c:y val="0.31421072632538022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lang="ja-JP" sz="12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dirty="0"/>
                      <a:t>y = 1208x + 1277</a:t>
                    </a:r>
                  </a:p>
                  <a:p>
                    <a:pPr>
                      <a:defRPr lang="ja-JP"/>
                    </a:pPr>
                    <a:r>
                      <a:rPr lang="en-US" dirty="0"/>
                      <a:t>    r = 0.435 ( p &lt; 0.05)</a:t>
                    </a:r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lang="ja-JP"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文字数と周辺視野!$A$2:$A$59</c:f>
              <c:numCache>
                <c:formatCode>0%</c:formatCode>
                <c:ptCount val="58"/>
                <c:pt idx="0">
                  <c:v>0.03</c:v>
                </c:pt>
                <c:pt idx="1">
                  <c:v>0</c:v>
                </c:pt>
                <c:pt idx="2">
                  <c:v>0.27</c:v>
                </c:pt>
                <c:pt idx="3">
                  <c:v>0.01</c:v>
                </c:pt>
                <c:pt idx="4">
                  <c:v>0</c:v>
                </c:pt>
                <c:pt idx="5">
                  <c:v>0.01</c:v>
                </c:pt>
                <c:pt idx="6">
                  <c:v>0.27</c:v>
                </c:pt>
                <c:pt idx="7">
                  <c:v>0.3</c:v>
                </c:pt>
                <c:pt idx="8">
                  <c:v>0.02</c:v>
                </c:pt>
                <c:pt idx="9">
                  <c:v>0.04</c:v>
                </c:pt>
                <c:pt idx="10">
                  <c:v>0</c:v>
                </c:pt>
                <c:pt idx="11">
                  <c:v>0.04</c:v>
                </c:pt>
                <c:pt idx="12">
                  <c:v>0.45</c:v>
                </c:pt>
                <c:pt idx="13">
                  <c:v>0</c:v>
                </c:pt>
                <c:pt idx="14">
                  <c:v>0.12</c:v>
                </c:pt>
                <c:pt idx="15">
                  <c:v>0.05</c:v>
                </c:pt>
                <c:pt idx="16">
                  <c:v>0.13</c:v>
                </c:pt>
                <c:pt idx="17">
                  <c:v>0.45</c:v>
                </c:pt>
                <c:pt idx="18">
                  <c:v>0.26</c:v>
                </c:pt>
                <c:pt idx="19">
                  <c:v>0.06</c:v>
                </c:pt>
                <c:pt idx="20">
                  <c:v>0.47</c:v>
                </c:pt>
                <c:pt idx="21">
                  <c:v>0.34</c:v>
                </c:pt>
                <c:pt idx="22">
                  <c:v>0.04</c:v>
                </c:pt>
                <c:pt idx="23">
                  <c:v>0.13</c:v>
                </c:pt>
                <c:pt idx="24">
                  <c:v>0.01</c:v>
                </c:pt>
                <c:pt idx="25">
                  <c:v>0.19</c:v>
                </c:pt>
                <c:pt idx="26">
                  <c:v>0.77</c:v>
                </c:pt>
              </c:numCache>
            </c:numRef>
          </c:xVal>
          <c:yVal>
            <c:numRef>
              <c:f>文字数と周辺視野!$B$2:$B$59</c:f>
              <c:numCache>
                <c:formatCode>General</c:formatCode>
                <c:ptCount val="58"/>
                <c:pt idx="0">
                  <c:v>537</c:v>
                </c:pt>
                <c:pt idx="1">
                  <c:v>484</c:v>
                </c:pt>
                <c:pt idx="2">
                  <c:v>1155</c:v>
                </c:pt>
                <c:pt idx="3">
                  <c:v>1509</c:v>
                </c:pt>
                <c:pt idx="4">
                  <c:v>1154</c:v>
                </c:pt>
                <c:pt idx="5">
                  <c:v>1160</c:v>
                </c:pt>
                <c:pt idx="6">
                  <c:v>808</c:v>
                </c:pt>
                <c:pt idx="7">
                  <c:v>1246</c:v>
                </c:pt>
                <c:pt idx="8">
                  <c:v>1185</c:v>
                </c:pt>
                <c:pt idx="9">
                  <c:v>1531</c:v>
                </c:pt>
                <c:pt idx="10">
                  <c:v>766</c:v>
                </c:pt>
                <c:pt idx="11">
                  <c:v>882</c:v>
                </c:pt>
                <c:pt idx="12">
                  <c:v>2841</c:v>
                </c:pt>
                <c:pt idx="13">
                  <c:v>2277</c:v>
                </c:pt>
                <c:pt idx="14">
                  <c:v>1875</c:v>
                </c:pt>
                <c:pt idx="15">
                  <c:v>1483</c:v>
                </c:pt>
                <c:pt idx="16">
                  <c:v>1264</c:v>
                </c:pt>
                <c:pt idx="17">
                  <c:v>1688</c:v>
                </c:pt>
                <c:pt idx="18">
                  <c:v>1350</c:v>
                </c:pt>
                <c:pt idx="19">
                  <c:v>1723</c:v>
                </c:pt>
                <c:pt idx="20">
                  <c:v>2199</c:v>
                </c:pt>
                <c:pt idx="21">
                  <c:v>1803</c:v>
                </c:pt>
                <c:pt idx="22">
                  <c:v>1811</c:v>
                </c:pt>
                <c:pt idx="23">
                  <c:v>1826</c:v>
                </c:pt>
                <c:pt idx="24">
                  <c:v>1866</c:v>
                </c:pt>
                <c:pt idx="25">
                  <c:v>1481</c:v>
                </c:pt>
                <c:pt idx="26">
                  <c:v>19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848-4CB3-A249-4FF6D9F0168F}"/>
            </c:ext>
          </c:extLst>
        </c:ser>
        <c:ser>
          <c:idx val="1"/>
          <c:order val="1"/>
          <c:tx>
            <c:v>P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周辺視野!$A$2:$A$59</c:f>
              <c:numCache>
                <c:formatCode>0%</c:formatCode>
                <c:ptCount val="58"/>
                <c:pt idx="0">
                  <c:v>0.03</c:v>
                </c:pt>
                <c:pt idx="1">
                  <c:v>0</c:v>
                </c:pt>
                <c:pt idx="2">
                  <c:v>0.27</c:v>
                </c:pt>
                <c:pt idx="3">
                  <c:v>0.01</c:v>
                </c:pt>
                <c:pt idx="4">
                  <c:v>0</c:v>
                </c:pt>
                <c:pt idx="5">
                  <c:v>0.01</c:v>
                </c:pt>
                <c:pt idx="6">
                  <c:v>0.27</c:v>
                </c:pt>
                <c:pt idx="7">
                  <c:v>0.3</c:v>
                </c:pt>
                <c:pt idx="8">
                  <c:v>0.02</c:v>
                </c:pt>
                <c:pt idx="9">
                  <c:v>0.04</c:v>
                </c:pt>
                <c:pt idx="10">
                  <c:v>0</c:v>
                </c:pt>
                <c:pt idx="11">
                  <c:v>0.04</c:v>
                </c:pt>
                <c:pt idx="12">
                  <c:v>0.45</c:v>
                </c:pt>
                <c:pt idx="13">
                  <c:v>0</c:v>
                </c:pt>
                <c:pt idx="14">
                  <c:v>0.12</c:v>
                </c:pt>
                <c:pt idx="15">
                  <c:v>0.05</c:v>
                </c:pt>
                <c:pt idx="16">
                  <c:v>0.13</c:v>
                </c:pt>
                <c:pt idx="17">
                  <c:v>0.45</c:v>
                </c:pt>
                <c:pt idx="18">
                  <c:v>0.26</c:v>
                </c:pt>
                <c:pt idx="19">
                  <c:v>0.06</c:v>
                </c:pt>
                <c:pt idx="20">
                  <c:v>0.47</c:v>
                </c:pt>
                <c:pt idx="21">
                  <c:v>0.34</c:v>
                </c:pt>
                <c:pt idx="22">
                  <c:v>0.04</c:v>
                </c:pt>
                <c:pt idx="23">
                  <c:v>0.13</c:v>
                </c:pt>
                <c:pt idx="24">
                  <c:v>0.01</c:v>
                </c:pt>
                <c:pt idx="25">
                  <c:v>0.19</c:v>
                </c:pt>
                <c:pt idx="26">
                  <c:v>0.77</c:v>
                </c:pt>
              </c:numCache>
            </c:numRef>
          </c:xVal>
          <c:yVal>
            <c:numRef>
              <c:f>文字数と周辺視野!$F$2:$F$59</c:f>
              <c:numCache>
                <c:formatCode>0.0_);[Red]\(0.0\)</c:formatCode>
                <c:ptCount val="58"/>
                <c:pt idx="0">
                  <c:v>2370.7474145126753</c:v>
                </c:pt>
                <c:pt idx="1">
                  <c:v>2339.0102974758897</c:v>
                </c:pt>
                <c:pt idx="2">
                  <c:v>2657.0964119845521</c:v>
                </c:pt>
                <c:pt idx="3">
                  <c:v>2349.4913342419886</c:v>
                </c:pt>
                <c:pt idx="4">
                  <c:v>2339.0102974758897</c:v>
                </c:pt>
                <c:pt idx="5">
                  <c:v>2349.4913342419886</c:v>
                </c:pt>
                <c:pt idx="6">
                  <c:v>2657.0964119845521</c:v>
                </c:pt>
                <c:pt idx="7">
                  <c:v>2696.9641234968085</c:v>
                </c:pt>
                <c:pt idx="8">
                  <c:v>2360.0702339748082</c:v>
                </c:pt>
                <c:pt idx="9">
                  <c:v>2381.5232685622459</c:v>
                </c:pt>
                <c:pt idx="10">
                  <c:v>2339.0102974758897</c:v>
                </c:pt>
                <c:pt idx="11">
                  <c:v>2381.5232685622459</c:v>
                </c:pt>
                <c:pt idx="12">
                  <c:v>2909.3701799913852</c:v>
                </c:pt>
                <c:pt idx="13">
                  <c:v>2339.0102974758897</c:v>
                </c:pt>
                <c:pt idx="14">
                  <c:v>2471.3207851659035</c:v>
                </c:pt>
                <c:pt idx="15">
                  <c:v>2392.3981631644301</c:v>
                </c:pt>
                <c:pt idx="16">
                  <c:v>2482.9979871028745</c:v>
                </c:pt>
                <c:pt idx="17">
                  <c:v>2909.3701799913852</c:v>
                </c:pt>
                <c:pt idx="18">
                  <c:v>2644.006161832313</c:v>
                </c:pt>
                <c:pt idx="19">
                  <c:v>2403.3724391908572</c:v>
                </c:pt>
                <c:pt idx="20">
                  <c:v>2939.2748080842503</c:v>
                </c:pt>
                <c:pt idx="21">
                  <c:v>2751.5005727742155</c:v>
                </c:pt>
                <c:pt idx="22">
                  <c:v>2381.5232685622459</c:v>
                </c:pt>
                <c:pt idx="23">
                  <c:v>2482.9979871028745</c:v>
                </c:pt>
                <c:pt idx="24">
                  <c:v>2349.4913342419886</c:v>
                </c:pt>
                <c:pt idx="25">
                  <c:v>2555.1867291370709</c:v>
                </c:pt>
                <c:pt idx="26">
                  <c:v>3427.0310046664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848-4CB3-A249-4FF6D9F0168F}"/>
            </c:ext>
          </c:extLst>
        </c:ser>
        <c:ser>
          <c:idx val="2"/>
          <c:order val="2"/>
          <c:tx>
            <c:v>P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周辺視野!$A$2:$A$59</c:f>
              <c:numCache>
                <c:formatCode>0%</c:formatCode>
                <c:ptCount val="58"/>
                <c:pt idx="0">
                  <c:v>0.03</c:v>
                </c:pt>
                <c:pt idx="1">
                  <c:v>0</c:v>
                </c:pt>
                <c:pt idx="2">
                  <c:v>0.27</c:v>
                </c:pt>
                <c:pt idx="3">
                  <c:v>0.01</c:v>
                </c:pt>
                <c:pt idx="4">
                  <c:v>0</c:v>
                </c:pt>
                <c:pt idx="5">
                  <c:v>0.01</c:v>
                </c:pt>
                <c:pt idx="6">
                  <c:v>0.27</c:v>
                </c:pt>
                <c:pt idx="7">
                  <c:v>0.3</c:v>
                </c:pt>
                <c:pt idx="8">
                  <c:v>0.02</c:v>
                </c:pt>
                <c:pt idx="9">
                  <c:v>0.04</c:v>
                </c:pt>
                <c:pt idx="10">
                  <c:v>0</c:v>
                </c:pt>
                <c:pt idx="11">
                  <c:v>0.04</c:v>
                </c:pt>
                <c:pt idx="12">
                  <c:v>0.45</c:v>
                </c:pt>
                <c:pt idx="13">
                  <c:v>0</c:v>
                </c:pt>
                <c:pt idx="14">
                  <c:v>0.12</c:v>
                </c:pt>
                <c:pt idx="15">
                  <c:v>0.05</c:v>
                </c:pt>
                <c:pt idx="16">
                  <c:v>0.13</c:v>
                </c:pt>
                <c:pt idx="17">
                  <c:v>0.45</c:v>
                </c:pt>
                <c:pt idx="18">
                  <c:v>0.26</c:v>
                </c:pt>
                <c:pt idx="19">
                  <c:v>0.06</c:v>
                </c:pt>
                <c:pt idx="20">
                  <c:v>0.47</c:v>
                </c:pt>
                <c:pt idx="21">
                  <c:v>0.34</c:v>
                </c:pt>
                <c:pt idx="22">
                  <c:v>0.04</c:v>
                </c:pt>
                <c:pt idx="23">
                  <c:v>0.13</c:v>
                </c:pt>
                <c:pt idx="24">
                  <c:v>0.01</c:v>
                </c:pt>
                <c:pt idx="25">
                  <c:v>0.19</c:v>
                </c:pt>
                <c:pt idx="26">
                  <c:v>0.77</c:v>
                </c:pt>
              </c:numCache>
            </c:numRef>
          </c:xVal>
          <c:yVal>
            <c:numRef>
              <c:f>文字数と周辺視野!$G$2:$G$59</c:f>
              <c:numCache>
                <c:formatCode>0.0_);[Red]\(0.0\)</c:formatCode>
                <c:ptCount val="58"/>
                <c:pt idx="0">
                  <c:v>255.72329729687567</c:v>
                </c:pt>
                <c:pt idx="1">
                  <c:v>214.95665448865702</c:v>
                </c:pt>
                <c:pt idx="2">
                  <c:v>549.40437858502924</c:v>
                </c:pt>
                <c:pt idx="3">
                  <c:v>228.64353767089278</c:v>
                </c:pt>
                <c:pt idx="4">
                  <c:v>214.95665448865702</c:v>
                </c:pt>
                <c:pt idx="5">
                  <c:v>228.64353767089278</c:v>
                </c:pt>
                <c:pt idx="6">
                  <c:v>549.40437858502924</c:v>
                </c:pt>
                <c:pt idx="7">
                  <c:v>582.04042691777681</c:v>
                </c:pt>
                <c:pt idx="8">
                  <c:v>242.2325578864079</c:v>
                </c:pt>
                <c:pt idx="9">
                  <c:v>269.1153631956397</c:v>
                </c:pt>
                <c:pt idx="10">
                  <c:v>214.95665448865702</c:v>
                </c:pt>
                <c:pt idx="11">
                  <c:v>269.1153631956397</c:v>
                </c:pt>
                <c:pt idx="12">
                  <c:v>732.15316964821886</c:v>
                </c:pt>
                <c:pt idx="13">
                  <c:v>214.95665448865702</c:v>
                </c:pt>
                <c:pt idx="14">
                  <c:v>372.66120617865886</c:v>
                </c:pt>
                <c:pt idx="15">
                  <c:v>282.40838854178946</c:v>
                </c:pt>
                <c:pt idx="16">
                  <c:v>385.15192419002256</c:v>
                </c:pt>
                <c:pt idx="17">
                  <c:v>732.15316964821886</c:v>
                </c:pt>
                <c:pt idx="18">
                  <c:v>538.32670878893396</c:v>
                </c:pt>
                <c:pt idx="19">
                  <c:v>295.60203246369701</c:v>
                </c:pt>
                <c:pt idx="20">
                  <c:v>750.58438145202331</c:v>
                </c:pt>
                <c:pt idx="21">
                  <c:v>624.17565743370801</c:v>
                </c:pt>
                <c:pt idx="22">
                  <c:v>269.1153631956397</c:v>
                </c:pt>
                <c:pt idx="23">
                  <c:v>385.15192419002256</c:v>
                </c:pt>
                <c:pt idx="24">
                  <c:v>228.64353767089278</c:v>
                </c:pt>
                <c:pt idx="25">
                  <c:v>457.97070184583367</c:v>
                </c:pt>
                <c:pt idx="26">
                  <c:v>987.865783319903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848-4CB3-A249-4FF6D9F0168F}"/>
            </c:ext>
          </c:extLst>
        </c:ser>
        <c:ser>
          <c:idx val="3"/>
          <c:order val="3"/>
          <c:tx>
            <c:v>CI+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周辺視野!$A$2:$A$59</c:f>
              <c:numCache>
                <c:formatCode>0%</c:formatCode>
                <c:ptCount val="58"/>
                <c:pt idx="0">
                  <c:v>0.03</c:v>
                </c:pt>
                <c:pt idx="1">
                  <c:v>0</c:v>
                </c:pt>
                <c:pt idx="2">
                  <c:v>0.27</c:v>
                </c:pt>
                <c:pt idx="3">
                  <c:v>0.01</c:v>
                </c:pt>
                <c:pt idx="4">
                  <c:v>0</c:v>
                </c:pt>
                <c:pt idx="5">
                  <c:v>0.01</c:v>
                </c:pt>
                <c:pt idx="6">
                  <c:v>0.27</c:v>
                </c:pt>
                <c:pt idx="7">
                  <c:v>0.3</c:v>
                </c:pt>
                <c:pt idx="8">
                  <c:v>0.02</c:v>
                </c:pt>
                <c:pt idx="9">
                  <c:v>0.04</c:v>
                </c:pt>
                <c:pt idx="10">
                  <c:v>0</c:v>
                </c:pt>
                <c:pt idx="11">
                  <c:v>0.04</c:v>
                </c:pt>
                <c:pt idx="12">
                  <c:v>0.45</c:v>
                </c:pt>
                <c:pt idx="13">
                  <c:v>0</c:v>
                </c:pt>
                <c:pt idx="14">
                  <c:v>0.12</c:v>
                </c:pt>
                <c:pt idx="15">
                  <c:v>0.05</c:v>
                </c:pt>
                <c:pt idx="16">
                  <c:v>0.13</c:v>
                </c:pt>
                <c:pt idx="17">
                  <c:v>0.45</c:v>
                </c:pt>
                <c:pt idx="18">
                  <c:v>0.26</c:v>
                </c:pt>
                <c:pt idx="19">
                  <c:v>0.06</c:v>
                </c:pt>
                <c:pt idx="20">
                  <c:v>0.47</c:v>
                </c:pt>
                <c:pt idx="21">
                  <c:v>0.34</c:v>
                </c:pt>
                <c:pt idx="22">
                  <c:v>0.04</c:v>
                </c:pt>
                <c:pt idx="23">
                  <c:v>0.13</c:v>
                </c:pt>
                <c:pt idx="24">
                  <c:v>0.01</c:v>
                </c:pt>
                <c:pt idx="25">
                  <c:v>0.19</c:v>
                </c:pt>
                <c:pt idx="26">
                  <c:v>0.77</c:v>
                </c:pt>
              </c:numCache>
            </c:numRef>
          </c:xVal>
          <c:yVal>
            <c:numRef>
              <c:f>文字数と周辺視野!$J$2:$J$59</c:f>
              <c:numCache>
                <c:formatCode>0.0_);[Red]\(0.0\)</c:formatCode>
                <c:ptCount val="58"/>
                <c:pt idx="0">
                  <c:v>1555.4216832344046</c:v>
                </c:pt>
                <c:pt idx="1">
                  <c:v>1538.1796333355751</c:v>
                </c:pt>
                <c:pt idx="2">
                  <c:v>1828.8914597173323</c:v>
                </c:pt>
                <c:pt idx="3">
                  <c:v>1543.6677248396525</c:v>
                </c:pt>
                <c:pt idx="4">
                  <c:v>1538.1796333355751</c:v>
                </c:pt>
                <c:pt idx="5">
                  <c:v>1543.6677248396525</c:v>
                </c:pt>
                <c:pt idx="6">
                  <c:v>1828.8914597173323</c:v>
                </c:pt>
                <c:pt idx="7">
                  <c:v>1881.4692639313246</c:v>
                </c:pt>
                <c:pt idx="8">
                  <c:v>1549.4084574800754</c:v>
                </c:pt>
                <c:pt idx="9">
                  <c:v>1561.7283950365115</c:v>
                </c:pt>
                <c:pt idx="10">
                  <c:v>1538.1796333355751</c:v>
                </c:pt>
                <c:pt idx="11">
                  <c:v>1561.7283950365115</c:v>
                </c:pt>
                <c:pt idx="12">
                  <c:v>2174.8675072713527</c:v>
                </c:pt>
                <c:pt idx="13">
                  <c:v>1538.1796333355751</c:v>
                </c:pt>
                <c:pt idx="14">
                  <c:v>1625.4989074669493</c:v>
                </c:pt>
                <c:pt idx="15">
                  <c:v>1568.3506189798973</c:v>
                </c:pt>
                <c:pt idx="16">
                  <c:v>1635.4750275531767</c:v>
                </c:pt>
                <c:pt idx="17">
                  <c:v>2174.8675072713527</c:v>
                </c:pt>
                <c:pt idx="18">
                  <c:v>1812.0599680058176</c:v>
                </c:pt>
                <c:pt idx="19">
                  <c:v>1575.3112489724506</c:v>
                </c:pt>
                <c:pt idx="20">
                  <c:v>2216.2972144554033</c:v>
                </c:pt>
                <c:pt idx="21">
                  <c:v>1955.6072076098405</c:v>
                </c:pt>
                <c:pt idx="22">
                  <c:v>1561.7283950365115</c:v>
                </c:pt>
                <c:pt idx="23">
                  <c:v>1635.4750275531767</c:v>
                </c:pt>
                <c:pt idx="24">
                  <c:v>1543.6677248396525</c:v>
                </c:pt>
                <c:pt idx="25">
                  <c:v>1706.3316361862612</c:v>
                </c:pt>
                <c:pt idx="26">
                  <c:v>2861.439378105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848-4CB3-A249-4FF6D9F0168F}"/>
            </c:ext>
          </c:extLst>
        </c:ser>
        <c:ser>
          <c:idx val="4"/>
          <c:order val="4"/>
          <c:tx>
            <c:v>CI-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文字数と周辺視野!$A$2:$A$59</c:f>
              <c:numCache>
                <c:formatCode>0%</c:formatCode>
                <c:ptCount val="58"/>
                <c:pt idx="0">
                  <c:v>0.03</c:v>
                </c:pt>
                <c:pt idx="1">
                  <c:v>0</c:v>
                </c:pt>
                <c:pt idx="2">
                  <c:v>0.27</c:v>
                </c:pt>
                <c:pt idx="3">
                  <c:v>0.01</c:v>
                </c:pt>
                <c:pt idx="4">
                  <c:v>0</c:v>
                </c:pt>
                <c:pt idx="5">
                  <c:v>0.01</c:v>
                </c:pt>
                <c:pt idx="6">
                  <c:v>0.27</c:v>
                </c:pt>
                <c:pt idx="7">
                  <c:v>0.3</c:v>
                </c:pt>
                <c:pt idx="8">
                  <c:v>0.02</c:v>
                </c:pt>
                <c:pt idx="9">
                  <c:v>0.04</c:v>
                </c:pt>
                <c:pt idx="10">
                  <c:v>0</c:v>
                </c:pt>
                <c:pt idx="11">
                  <c:v>0.04</c:v>
                </c:pt>
                <c:pt idx="12">
                  <c:v>0.45</c:v>
                </c:pt>
                <c:pt idx="13">
                  <c:v>0</c:v>
                </c:pt>
                <c:pt idx="14">
                  <c:v>0.12</c:v>
                </c:pt>
                <c:pt idx="15">
                  <c:v>0.05</c:v>
                </c:pt>
                <c:pt idx="16">
                  <c:v>0.13</c:v>
                </c:pt>
                <c:pt idx="17">
                  <c:v>0.45</c:v>
                </c:pt>
                <c:pt idx="18">
                  <c:v>0.26</c:v>
                </c:pt>
                <c:pt idx="19">
                  <c:v>0.06</c:v>
                </c:pt>
                <c:pt idx="20">
                  <c:v>0.47</c:v>
                </c:pt>
                <c:pt idx="21">
                  <c:v>0.34</c:v>
                </c:pt>
                <c:pt idx="22">
                  <c:v>0.04</c:v>
                </c:pt>
                <c:pt idx="23">
                  <c:v>0.13</c:v>
                </c:pt>
                <c:pt idx="24">
                  <c:v>0.01</c:v>
                </c:pt>
                <c:pt idx="25">
                  <c:v>0.19</c:v>
                </c:pt>
                <c:pt idx="26">
                  <c:v>0.77</c:v>
                </c:pt>
              </c:numCache>
            </c:numRef>
          </c:xVal>
          <c:yVal>
            <c:numRef>
              <c:f>文字数と周辺視野!$K$2:$K$59</c:f>
              <c:numCache>
                <c:formatCode>0.0_);[Red]\(0.0\)</c:formatCode>
                <c:ptCount val="58"/>
                <c:pt idx="0">
                  <c:v>1071.0490285751462</c:v>
                </c:pt>
                <c:pt idx="1">
                  <c:v>1015.7873186289718</c:v>
                </c:pt>
                <c:pt idx="2">
                  <c:v>1377.6093308522488</c:v>
                </c:pt>
                <c:pt idx="3">
                  <c:v>1034.4671470732289</c:v>
                </c:pt>
                <c:pt idx="4">
                  <c:v>1015.7873186289718</c:v>
                </c:pt>
                <c:pt idx="5">
                  <c:v>1034.4671470732289</c:v>
                </c:pt>
                <c:pt idx="6">
                  <c:v>1377.6093308522488</c:v>
                </c:pt>
                <c:pt idx="7">
                  <c:v>1397.5352864832605</c:v>
                </c:pt>
                <c:pt idx="8">
                  <c:v>1052.8943343811407</c:v>
                </c:pt>
                <c:pt idx="9">
                  <c:v>1088.9102367213738</c:v>
                </c:pt>
                <c:pt idx="10">
                  <c:v>1015.7873186289718</c:v>
                </c:pt>
                <c:pt idx="11">
                  <c:v>1088.9102367213738</c:v>
                </c:pt>
                <c:pt idx="12">
                  <c:v>1466.6558423682513</c:v>
                </c:pt>
                <c:pt idx="13">
                  <c:v>1015.7873186289718</c:v>
                </c:pt>
                <c:pt idx="14">
                  <c:v>1218.4830838776129</c:v>
                </c:pt>
                <c:pt idx="15">
                  <c:v>1106.4559327263223</c:v>
                </c:pt>
                <c:pt idx="16">
                  <c:v>1232.6748837397201</c:v>
                </c:pt>
                <c:pt idx="17">
                  <c:v>1466.6558423682513</c:v>
                </c:pt>
                <c:pt idx="18">
                  <c:v>1370.2729026154293</c:v>
                </c:pt>
                <c:pt idx="19">
                  <c:v>1123.6632226821037</c:v>
                </c:pt>
                <c:pt idx="20">
                  <c:v>1473.5619750808701</c:v>
                </c:pt>
                <c:pt idx="21">
                  <c:v>1420.0690225980832</c:v>
                </c:pt>
                <c:pt idx="22">
                  <c:v>1088.9102367213738</c:v>
                </c:pt>
                <c:pt idx="23">
                  <c:v>1232.6748837397201</c:v>
                </c:pt>
                <c:pt idx="24">
                  <c:v>1034.4671470732289</c:v>
                </c:pt>
                <c:pt idx="25">
                  <c:v>1306.8257947966431</c:v>
                </c:pt>
                <c:pt idx="26">
                  <c:v>1553.45740988031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848-4CB3-A249-4FF6D9F016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5222416"/>
        <c:axId val="865216840"/>
      </c:scatterChart>
      <c:valAx>
        <c:axId val="865222416"/>
        <c:scaling>
          <c:orientation val="minMax"/>
          <c:max val="0.8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V/4 periphery (%)</a:t>
                </a:r>
              </a:p>
            </c:rich>
          </c:tx>
          <c:layout>
            <c:manualLayout>
              <c:xMode val="edge"/>
              <c:yMode val="edge"/>
              <c:x val="0.38253266036230954"/>
              <c:y val="0.900528719459457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16840"/>
        <c:crossesAt val="-1000"/>
        <c:crossBetween val="midCat"/>
      </c:valAx>
      <c:valAx>
        <c:axId val="865216840"/>
        <c:scaling>
          <c:orientation val="minMax"/>
          <c:max val="4000"/>
          <c:min val="-100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letter correctly read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2.1320988278469384E-3"/>
              <c:y val="4.295165734514080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5222416"/>
        <c:crossesAt val="-40"/>
        <c:crossBetween val="midCat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105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927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635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855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014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068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8056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9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407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43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188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A8BEB-CE82-4401-B6FC-E9C8CC0676C7}" type="datetimeFigureOut">
              <a:rPr kumimoji="1" lang="ja-JP" altLang="en-US" smtClean="0"/>
              <a:t>2022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AC694-AC0F-4A26-AB20-4430698A46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71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kumimoji="1"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DB84D42-1944-4669-C56B-887429A1E9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6308911"/>
              </p:ext>
            </p:extLst>
          </p:nvPr>
        </p:nvGraphicFramePr>
        <p:xfrm>
          <a:off x="6707140" y="3720785"/>
          <a:ext cx="4687869" cy="2930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C85D300A-6F9F-2F5A-AA27-6511FF28C8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8179822"/>
              </p:ext>
            </p:extLst>
          </p:nvPr>
        </p:nvGraphicFramePr>
        <p:xfrm>
          <a:off x="579863" y="301083"/>
          <a:ext cx="5018049" cy="29048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FC15FE84-EC45-EAD9-4162-885C780B3B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0945941"/>
              </p:ext>
            </p:extLst>
          </p:nvPr>
        </p:nvGraphicFramePr>
        <p:xfrm>
          <a:off x="6594090" y="366562"/>
          <a:ext cx="4672629" cy="2719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04E1CF1-7860-B9AC-08A0-93300EDD5609}"/>
              </a:ext>
            </a:extLst>
          </p:cNvPr>
          <p:cNvSpPr txBox="1"/>
          <p:nvPr/>
        </p:nvSpPr>
        <p:spPr>
          <a:xfrm>
            <a:off x="356839" y="301083"/>
            <a:ext cx="351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45185B2-AD5A-45D7-5476-0B16CC1DA1FA}"/>
              </a:ext>
            </a:extLst>
          </p:cNvPr>
          <p:cNvSpPr txBox="1"/>
          <p:nvPr/>
        </p:nvSpPr>
        <p:spPr>
          <a:xfrm>
            <a:off x="6282695" y="301083"/>
            <a:ext cx="351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AEB7B219-D56F-CB46-6053-38D487E87A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9656250"/>
              </p:ext>
            </p:extLst>
          </p:nvPr>
        </p:nvGraphicFramePr>
        <p:xfrm>
          <a:off x="796991" y="3720785"/>
          <a:ext cx="4687869" cy="28130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9317DD6-778B-112A-3A70-0288BD90A2B4}"/>
              </a:ext>
            </a:extLst>
          </p:cNvPr>
          <p:cNvSpPr txBox="1"/>
          <p:nvPr/>
        </p:nvSpPr>
        <p:spPr>
          <a:xfrm>
            <a:off x="375427" y="3720785"/>
            <a:ext cx="351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2AE608A-D2A3-8677-C458-AB654E321FE3}"/>
              </a:ext>
            </a:extLst>
          </p:cNvPr>
          <p:cNvSpPr txBox="1"/>
          <p:nvPr/>
        </p:nvSpPr>
        <p:spPr>
          <a:xfrm>
            <a:off x="6281843" y="3728223"/>
            <a:ext cx="351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3753FB9-C389-CEFC-8AFA-4D6FF684D41B}"/>
              </a:ext>
            </a:extLst>
          </p:cNvPr>
          <p:cNvSpPr txBox="1"/>
          <p:nvPr/>
        </p:nvSpPr>
        <p:spPr>
          <a:xfrm>
            <a:off x="215821" y="6372250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5268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47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明敏 精山</dc:creator>
  <cp:lastModifiedBy>yoshida</cp:lastModifiedBy>
  <cp:revision>13</cp:revision>
  <dcterms:created xsi:type="dcterms:W3CDTF">2022-11-02T18:52:54Z</dcterms:created>
  <dcterms:modified xsi:type="dcterms:W3CDTF">2022-11-18T16:23:15Z</dcterms:modified>
</cp:coreProperties>
</file>